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6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38" y="4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DF4B72-9672-48CD-8E60-2B6066CAF4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CC06672-9592-4DD7-AE0D-07B497C7DE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E3A79D-309C-4383-A748-540E2E0749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6D651-4FD6-4793-B698-4945B623177E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3785C9-2B0C-47AE-8693-0BA17F3748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1B01D8-A22C-45C8-B05A-6870901514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DEEB1-7659-4FC6-B908-883F2F77BE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212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5B383E-6A4F-4EE5-82C3-A06F2B2C9F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00504D-D4A5-4ED7-A7CC-7D36A45564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82F1A4-1669-4ACF-A413-A62E308EB1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6D651-4FD6-4793-B698-4945B623177E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3FA713-C8F9-4572-B491-9F98163D34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CFEE0C-B097-4BC2-813C-9F4D53DFBC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DEEB1-7659-4FC6-B908-883F2F77BE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573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A54DA45-3604-448D-8CCC-241531D1D5C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31F2FF-0A04-4A8B-83F7-A064F792A8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F29148-D0B2-4177-AD90-B56BC5420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6D651-4FD6-4793-B698-4945B623177E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270E5E-6790-4FF8-8FAC-9E76D0ED1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33E8A5-2995-4499-BF93-A48B861CAB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DEEB1-7659-4FC6-B908-883F2F77BE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724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3BF243-A8B6-42EC-A49A-343D6C71D5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61EDB9-FECA-4AB4-ADE3-97838324982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A654BD-C0F4-4BA7-8790-01BA62CEDC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6D651-4FD6-4793-B698-4945B623177E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59D9D3-287B-4F74-AC64-77A4C625AD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9F14B8-3FD4-4CA4-BCD8-890E7ED7DC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DEEB1-7659-4FC6-B908-883F2F77BE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682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16D565-9D59-4FAF-8FBC-34A8BF4AE1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B79552-5853-4FA6-BC55-4D73069F36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50577B-5BCD-4D4D-9889-0331502D8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6D651-4FD6-4793-B698-4945B623177E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E2299C-7723-498E-972A-A4BD40598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086B3E-8F00-4324-92AF-1887CDA004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DEEB1-7659-4FC6-B908-883F2F77BE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736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D0EF50-084C-48E4-A724-714D523260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F74108-5792-4E28-B4AA-A2825F31D0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5D25AD-D7C7-49BF-B189-6999136774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09FAA6-224F-46D4-B7CD-06A7E8643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6D651-4FD6-4793-B698-4945B623177E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8C96E1-15B4-4B16-8C0B-CBA66B5C29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4EB0B3-5416-4A74-B9B7-3E76B3A90F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DEEB1-7659-4FC6-B908-883F2F77BE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591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40FC0E-E67A-4D1D-94F3-CC315DBF60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81F5BC-544F-4D3B-8087-721BB30165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FF6371-5A98-4742-810D-FDE8409CBD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B53685E-CDA1-4D48-B7A0-63C359C9116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B3105AA-855E-4490-98AA-5BC878151B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A0B0F5B-39E7-4AC5-AE9C-AA39D43AA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6D651-4FD6-4793-B698-4945B623177E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2B2C0C4-0C22-4881-8238-8563357EED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093E2C0-6374-49CC-9BBF-7029F554C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DEEB1-7659-4FC6-B908-883F2F77BE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492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58E94F-4DC5-49EC-A918-D05DA4F7E1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D75489-C933-4A04-924C-29B05C9498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6D651-4FD6-4793-B698-4945B623177E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BC379B8-5D36-4D92-A05B-034F8A1B3B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6D14D4C-9869-4D61-AA02-DBEEBAF39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DEEB1-7659-4FC6-B908-883F2F77BE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681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FDD56FB-B6E7-45CF-AC19-CF8379A3E6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6D651-4FD6-4793-B698-4945B623177E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8C50FAB-1EC9-44FB-ACF8-6D9127E7B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DE2BDCB-6161-4978-AF77-288356C24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DEEB1-7659-4FC6-B908-883F2F77BE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540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F2FFFD-2CD6-4B31-8169-856540065B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589218-9692-4B38-B39F-3EE1B489EA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870B95-CD34-4DFD-8F3A-EE38FC2D47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B32C65-0FA2-41D4-85B2-06CA00393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6D651-4FD6-4793-B698-4945B623177E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91238B-1EDC-4BD7-A869-75FC0BD0F4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5A487D-EE45-4994-94F5-AFA40FC35F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DEEB1-7659-4FC6-B908-883F2F77BE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765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D28EA0-CEAB-4B3C-ADB6-D872237452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B223C85-E581-4477-985F-56074C2D30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85B2E3-4B64-430F-B99C-CCFEF9E3D4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9A4389-4CFE-4544-886F-A80F44125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6D651-4FD6-4793-B698-4945B623177E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9798E2-2F31-40A9-94EE-E06E2669E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5F001D-752E-449F-9AAC-348363523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DEEB1-7659-4FC6-B908-883F2F77BE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209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E68944F-55D9-46BE-AE19-51D3469BC9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27F8F7-5699-4445-A0E5-C076FD0972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32B050-A62E-424B-BD44-4B306A73F4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D6D651-4FD6-4793-B698-4945B623177E}" type="datetimeFigureOut">
              <a:rPr lang="en-US" smtClean="0"/>
              <a:t>2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65879C-2BA4-47C2-9118-D25581C74A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D3E256-8521-4377-9D2A-F8276E65EB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7DEEB1-7659-4FC6-B908-883F2F77BE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398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LSI002_06_110947_NIRFLI images-1.avi_L axilla">
            <a:hlinkClick r:id="" action="ppaction://media"/>
            <a:extLst>
              <a:ext uri="{FF2B5EF4-FFF2-40B4-BE49-F238E27FC236}">
                <a16:creationId xmlns:a16="http://schemas.microsoft.com/office/drawing/2014/main" id="{090680D0-DEB0-45BA-9310-4F64439CD0B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378953" y="833716"/>
            <a:ext cx="4876800" cy="4876800"/>
          </a:xfrm>
          <a:prstGeom prst="rect">
            <a:avLst/>
          </a:prstGeom>
        </p:spPr>
      </p:pic>
      <p:sp>
        <p:nvSpPr>
          <p:cNvPr id="6" name="Freeform: Shape 5">
            <a:extLst>
              <a:ext uri="{FF2B5EF4-FFF2-40B4-BE49-F238E27FC236}">
                <a16:creationId xmlns:a16="http://schemas.microsoft.com/office/drawing/2014/main" id="{210D9377-D478-41E6-BEE7-B963F7C6BF19}"/>
              </a:ext>
            </a:extLst>
          </p:cNvPr>
          <p:cNvSpPr/>
          <p:nvPr/>
        </p:nvSpPr>
        <p:spPr>
          <a:xfrm>
            <a:off x="5213023" y="1234911"/>
            <a:ext cx="2535214" cy="3959258"/>
          </a:xfrm>
          <a:custGeom>
            <a:avLst/>
            <a:gdLst>
              <a:gd name="connsiteX0" fmla="*/ 0 w 2535214"/>
              <a:gd name="connsiteY0" fmla="*/ 0 h 3846136"/>
              <a:gd name="connsiteX1" fmla="*/ 1781666 w 2535214"/>
              <a:gd name="connsiteY1" fmla="*/ 716437 h 3846136"/>
              <a:gd name="connsiteX2" fmla="*/ 2516956 w 2535214"/>
              <a:gd name="connsiteY2" fmla="*/ 1310326 h 3846136"/>
              <a:gd name="connsiteX3" fmla="*/ 2281286 w 2535214"/>
              <a:gd name="connsiteY3" fmla="*/ 2724347 h 3846136"/>
              <a:gd name="connsiteX4" fmla="*/ 1941921 w 2535214"/>
              <a:gd name="connsiteY4" fmla="*/ 3553905 h 3846136"/>
              <a:gd name="connsiteX5" fmla="*/ 1564849 w 2535214"/>
              <a:gd name="connsiteY5" fmla="*/ 3846136 h 3846136"/>
              <a:gd name="connsiteX0" fmla="*/ 0 w 2535214"/>
              <a:gd name="connsiteY0" fmla="*/ 0 h 3959258"/>
              <a:gd name="connsiteX1" fmla="*/ 1781666 w 2535214"/>
              <a:gd name="connsiteY1" fmla="*/ 716437 h 3959258"/>
              <a:gd name="connsiteX2" fmla="*/ 2516956 w 2535214"/>
              <a:gd name="connsiteY2" fmla="*/ 1310326 h 3959258"/>
              <a:gd name="connsiteX3" fmla="*/ 2281286 w 2535214"/>
              <a:gd name="connsiteY3" fmla="*/ 2724347 h 3959258"/>
              <a:gd name="connsiteX4" fmla="*/ 1941921 w 2535214"/>
              <a:gd name="connsiteY4" fmla="*/ 3553905 h 3959258"/>
              <a:gd name="connsiteX5" fmla="*/ 1706251 w 2535214"/>
              <a:gd name="connsiteY5" fmla="*/ 3959258 h 39592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214" h="3959258">
                <a:moveTo>
                  <a:pt x="0" y="0"/>
                </a:moveTo>
                <a:cubicBezTo>
                  <a:pt x="681086" y="249024"/>
                  <a:pt x="1362173" y="498049"/>
                  <a:pt x="1781666" y="716437"/>
                </a:cubicBezTo>
                <a:cubicBezTo>
                  <a:pt x="2201159" y="934825"/>
                  <a:pt x="2433686" y="975675"/>
                  <a:pt x="2516956" y="1310326"/>
                </a:cubicBezTo>
                <a:cubicBezTo>
                  <a:pt x="2600226" y="1644977"/>
                  <a:pt x="2377125" y="2350417"/>
                  <a:pt x="2281286" y="2724347"/>
                </a:cubicBezTo>
                <a:cubicBezTo>
                  <a:pt x="2185447" y="3098277"/>
                  <a:pt x="2037760" y="3348087"/>
                  <a:pt x="1941921" y="3553905"/>
                </a:cubicBezTo>
                <a:cubicBezTo>
                  <a:pt x="1846082" y="3759723"/>
                  <a:pt x="1835084" y="3906625"/>
                  <a:pt x="1706251" y="3959258"/>
                </a:cubicBezTo>
              </a:path>
            </a:pathLst>
          </a:custGeom>
          <a:noFill/>
          <a:ln>
            <a:solidFill>
              <a:srgbClr val="FFFF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Freeform: Shape 6">
            <a:extLst>
              <a:ext uri="{FF2B5EF4-FFF2-40B4-BE49-F238E27FC236}">
                <a16:creationId xmlns:a16="http://schemas.microsoft.com/office/drawing/2014/main" id="{F0EBB260-8777-453C-8DCD-716AFE30FDC7}"/>
              </a:ext>
            </a:extLst>
          </p:cNvPr>
          <p:cNvSpPr/>
          <p:nvPr/>
        </p:nvSpPr>
        <p:spPr>
          <a:xfrm>
            <a:off x="4901938" y="1781666"/>
            <a:ext cx="1681473" cy="1122475"/>
          </a:xfrm>
          <a:custGeom>
            <a:avLst/>
            <a:gdLst>
              <a:gd name="connsiteX0" fmla="*/ 0 w 1681473"/>
              <a:gd name="connsiteY0" fmla="*/ 0 h 1122475"/>
              <a:gd name="connsiteX1" fmla="*/ 622169 w 1681473"/>
              <a:gd name="connsiteY1" fmla="*/ 433633 h 1122475"/>
              <a:gd name="connsiteX2" fmla="*/ 1093509 w 1681473"/>
              <a:gd name="connsiteY2" fmla="*/ 763571 h 1122475"/>
              <a:gd name="connsiteX3" fmla="*/ 1385740 w 1681473"/>
              <a:gd name="connsiteY3" fmla="*/ 933254 h 1122475"/>
              <a:gd name="connsiteX4" fmla="*/ 1640264 w 1681473"/>
              <a:gd name="connsiteY4" fmla="*/ 1093509 h 1122475"/>
              <a:gd name="connsiteX5" fmla="*/ 1677971 w 1681473"/>
              <a:gd name="connsiteY5" fmla="*/ 1121790 h 11224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681473" h="1122475">
                <a:moveTo>
                  <a:pt x="0" y="0"/>
                </a:moveTo>
                <a:lnTo>
                  <a:pt x="622169" y="433633"/>
                </a:lnTo>
                <a:cubicBezTo>
                  <a:pt x="804420" y="560895"/>
                  <a:pt x="966247" y="680301"/>
                  <a:pt x="1093509" y="763571"/>
                </a:cubicBezTo>
                <a:cubicBezTo>
                  <a:pt x="1220771" y="846841"/>
                  <a:pt x="1294614" y="878264"/>
                  <a:pt x="1385740" y="933254"/>
                </a:cubicBezTo>
                <a:cubicBezTo>
                  <a:pt x="1476866" y="988244"/>
                  <a:pt x="1640264" y="1093509"/>
                  <a:pt x="1640264" y="1093509"/>
                </a:cubicBezTo>
                <a:cubicBezTo>
                  <a:pt x="1688969" y="1124932"/>
                  <a:pt x="1683470" y="1123361"/>
                  <a:pt x="1677971" y="1121790"/>
                </a:cubicBezTo>
              </a:path>
            </a:pathLst>
          </a:custGeom>
          <a:noFill/>
          <a:ln>
            <a:solidFill>
              <a:srgbClr val="FFFF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Freeform: Shape 7">
            <a:extLst>
              <a:ext uri="{FF2B5EF4-FFF2-40B4-BE49-F238E27FC236}">
                <a16:creationId xmlns:a16="http://schemas.microsoft.com/office/drawing/2014/main" id="{B1C4B559-375A-44C0-877F-7109FD9F0EF0}"/>
              </a:ext>
            </a:extLst>
          </p:cNvPr>
          <p:cNvSpPr/>
          <p:nvPr/>
        </p:nvSpPr>
        <p:spPr>
          <a:xfrm>
            <a:off x="5854045" y="2875175"/>
            <a:ext cx="688157" cy="1355928"/>
          </a:xfrm>
          <a:custGeom>
            <a:avLst/>
            <a:gdLst>
              <a:gd name="connsiteX0" fmla="*/ 688157 w 688157"/>
              <a:gd name="connsiteY0" fmla="*/ 0 h 1355928"/>
              <a:gd name="connsiteX1" fmla="*/ 527901 w 688157"/>
              <a:gd name="connsiteY1" fmla="*/ 537328 h 1355928"/>
              <a:gd name="connsiteX2" fmla="*/ 320512 w 688157"/>
              <a:gd name="connsiteY2" fmla="*/ 999241 h 1355928"/>
              <a:gd name="connsiteX3" fmla="*/ 141402 w 688157"/>
              <a:gd name="connsiteY3" fmla="*/ 1310326 h 1355928"/>
              <a:gd name="connsiteX4" fmla="*/ 0 w 688157"/>
              <a:gd name="connsiteY4" fmla="*/ 1348033 h 13559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688157" h="1355928">
                <a:moveTo>
                  <a:pt x="688157" y="0"/>
                </a:moveTo>
                <a:cubicBezTo>
                  <a:pt x="638666" y="185394"/>
                  <a:pt x="589175" y="370788"/>
                  <a:pt x="527901" y="537328"/>
                </a:cubicBezTo>
                <a:cubicBezTo>
                  <a:pt x="466627" y="703868"/>
                  <a:pt x="384928" y="870408"/>
                  <a:pt x="320512" y="999241"/>
                </a:cubicBezTo>
                <a:cubicBezTo>
                  <a:pt x="256096" y="1128074"/>
                  <a:pt x="194821" y="1252194"/>
                  <a:pt x="141402" y="1310326"/>
                </a:cubicBezTo>
                <a:cubicBezTo>
                  <a:pt x="87983" y="1368458"/>
                  <a:pt x="43991" y="1358245"/>
                  <a:pt x="0" y="1348033"/>
                </a:cubicBezTo>
              </a:path>
            </a:pathLst>
          </a:custGeom>
          <a:noFill/>
          <a:ln>
            <a:solidFill>
              <a:srgbClr val="FFFF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Freeform 78">
            <a:extLst>
              <a:ext uri="{FF2B5EF4-FFF2-40B4-BE49-F238E27FC236}">
                <a16:creationId xmlns:a16="http://schemas.microsoft.com/office/drawing/2014/main" id="{8B4477D3-AFF3-458A-A8A2-C5B8EF8C5E23}"/>
              </a:ext>
            </a:extLst>
          </p:cNvPr>
          <p:cNvSpPr/>
          <p:nvPr/>
        </p:nvSpPr>
        <p:spPr>
          <a:xfrm>
            <a:off x="4136789" y="2714122"/>
            <a:ext cx="1219214" cy="1429755"/>
          </a:xfrm>
          <a:custGeom>
            <a:avLst/>
            <a:gdLst>
              <a:gd name="connsiteX0" fmla="*/ 0 w 1722238"/>
              <a:gd name="connsiteY0" fmla="*/ 1148229 h 2678579"/>
              <a:gd name="connsiteX1" fmla="*/ 12700 w 1722238"/>
              <a:gd name="connsiteY1" fmla="*/ 1275229 h 2678579"/>
              <a:gd name="connsiteX2" fmla="*/ 31750 w 1722238"/>
              <a:gd name="connsiteY2" fmla="*/ 1351429 h 2678579"/>
              <a:gd name="connsiteX3" fmla="*/ 215900 w 1722238"/>
              <a:gd name="connsiteY3" fmla="*/ 1414929 h 2678579"/>
              <a:gd name="connsiteX4" fmla="*/ 349250 w 1722238"/>
              <a:gd name="connsiteY4" fmla="*/ 1395879 h 2678579"/>
              <a:gd name="connsiteX5" fmla="*/ 482600 w 1722238"/>
              <a:gd name="connsiteY5" fmla="*/ 1364129 h 2678579"/>
              <a:gd name="connsiteX6" fmla="*/ 749300 w 1722238"/>
              <a:gd name="connsiteY6" fmla="*/ 1395879 h 2678579"/>
              <a:gd name="connsiteX7" fmla="*/ 825500 w 1722238"/>
              <a:gd name="connsiteY7" fmla="*/ 1383179 h 2678579"/>
              <a:gd name="connsiteX8" fmla="*/ 958850 w 1722238"/>
              <a:gd name="connsiteY8" fmla="*/ 1351429 h 2678579"/>
              <a:gd name="connsiteX9" fmla="*/ 1092200 w 1722238"/>
              <a:gd name="connsiteY9" fmla="*/ 1319679 h 2678579"/>
              <a:gd name="connsiteX10" fmla="*/ 1193800 w 1722238"/>
              <a:gd name="connsiteY10" fmla="*/ 1300629 h 2678579"/>
              <a:gd name="connsiteX11" fmla="*/ 1244600 w 1722238"/>
              <a:gd name="connsiteY11" fmla="*/ 1287929 h 2678579"/>
              <a:gd name="connsiteX12" fmla="*/ 1162050 w 1722238"/>
              <a:gd name="connsiteY12" fmla="*/ 1141879 h 2678579"/>
              <a:gd name="connsiteX13" fmla="*/ 1092200 w 1722238"/>
              <a:gd name="connsiteY13" fmla="*/ 983129 h 2678579"/>
              <a:gd name="connsiteX14" fmla="*/ 1003300 w 1722238"/>
              <a:gd name="connsiteY14" fmla="*/ 849779 h 2678579"/>
              <a:gd name="connsiteX15" fmla="*/ 882650 w 1722238"/>
              <a:gd name="connsiteY15" fmla="*/ 684679 h 2678579"/>
              <a:gd name="connsiteX16" fmla="*/ 793750 w 1722238"/>
              <a:gd name="connsiteY16" fmla="*/ 589429 h 2678579"/>
              <a:gd name="connsiteX17" fmla="*/ 673100 w 1722238"/>
              <a:gd name="connsiteY17" fmla="*/ 583079 h 2678579"/>
              <a:gd name="connsiteX18" fmla="*/ 622300 w 1722238"/>
              <a:gd name="connsiteY18" fmla="*/ 583079 h 2678579"/>
              <a:gd name="connsiteX19" fmla="*/ 546100 w 1722238"/>
              <a:gd name="connsiteY19" fmla="*/ 544979 h 2678579"/>
              <a:gd name="connsiteX20" fmla="*/ 495300 w 1722238"/>
              <a:gd name="connsiteY20" fmla="*/ 519579 h 2678579"/>
              <a:gd name="connsiteX21" fmla="*/ 444500 w 1722238"/>
              <a:gd name="connsiteY21" fmla="*/ 487829 h 2678579"/>
              <a:gd name="connsiteX22" fmla="*/ 400050 w 1722238"/>
              <a:gd name="connsiteY22" fmla="*/ 475129 h 2678579"/>
              <a:gd name="connsiteX23" fmla="*/ 387350 w 1722238"/>
              <a:gd name="connsiteY23" fmla="*/ 449729 h 2678579"/>
              <a:gd name="connsiteX24" fmla="*/ 419100 w 1722238"/>
              <a:gd name="connsiteY24" fmla="*/ 430679 h 2678579"/>
              <a:gd name="connsiteX25" fmla="*/ 495300 w 1722238"/>
              <a:gd name="connsiteY25" fmla="*/ 443379 h 2678579"/>
              <a:gd name="connsiteX26" fmla="*/ 539750 w 1722238"/>
              <a:gd name="connsiteY26" fmla="*/ 468779 h 2678579"/>
              <a:gd name="connsiteX27" fmla="*/ 571500 w 1722238"/>
              <a:gd name="connsiteY27" fmla="*/ 456079 h 2678579"/>
              <a:gd name="connsiteX28" fmla="*/ 571500 w 1722238"/>
              <a:gd name="connsiteY28" fmla="*/ 462429 h 2678579"/>
              <a:gd name="connsiteX29" fmla="*/ 539750 w 1722238"/>
              <a:gd name="connsiteY29" fmla="*/ 411629 h 2678579"/>
              <a:gd name="connsiteX30" fmla="*/ 469900 w 1722238"/>
              <a:gd name="connsiteY30" fmla="*/ 360829 h 2678579"/>
              <a:gd name="connsiteX31" fmla="*/ 374650 w 1722238"/>
              <a:gd name="connsiteY31" fmla="*/ 322729 h 2678579"/>
              <a:gd name="connsiteX32" fmla="*/ 317500 w 1722238"/>
              <a:gd name="connsiteY32" fmla="*/ 290979 h 2678579"/>
              <a:gd name="connsiteX33" fmla="*/ 298450 w 1722238"/>
              <a:gd name="connsiteY33" fmla="*/ 259229 h 2678579"/>
              <a:gd name="connsiteX34" fmla="*/ 298450 w 1722238"/>
              <a:gd name="connsiteY34" fmla="*/ 221129 h 2678579"/>
              <a:gd name="connsiteX35" fmla="*/ 330200 w 1722238"/>
              <a:gd name="connsiteY35" fmla="*/ 214779 h 2678579"/>
              <a:gd name="connsiteX36" fmla="*/ 368300 w 1722238"/>
              <a:gd name="connsiteY36" fmla="*/ 240179 h 2678579"/>
              <a:gd name="connsiteX37" fmla="*/ 450850 w 1722238"/>
              <a:gd name="connsiteY37" fmla="*/ 278279 h 2678579"/>
              <a:gd name="connsiteX38" fmla="*/ 508000 w 1722238"/>
              <a:gd name="connsiteY38" fmla="*/ 303679 h 2678579"/>
              <a:gd name="connsiteX39" fmla="*/ 546100 w 1722238"/>
              <a:gd name="connsiteY39" fmla="*/ 322729 h 2678579"/>
              <a:gd name="connsiteX40" fmla="*/ 495300 w 1722238"/>
              <a:gd name="connsiteY40" fmla="*/ 265579 h 2678579"/>
              <a:gd name="connsiteX41" fmla="*/ 425450 w 1722238"/>
              <a:gd name="connsiteY41" fmla="*/ 221129 h 2678579"/>
              <a:gd name="connsiteX42" fmla="*/ 349250 w 1722238"/>
              <a:gd name="connsiteY42" fmla="*/ 189379 h 2678579"/>
              <a:gd name="connsiteX43" fmla="*/ 317500 w 1722238"/>
              <a:gd name="connsiteY43" fmla="*/ 170329 h 2678579"/>
              <a:gd name="connsiteX44" fmla="*/ 285750 w 1722238"/>
              <a:gd name="connsiteY44" fmla="*/ 106829 h 2678579"/>
              <a:gd name="connsiteX45" fmla="*/ 330200 w 1722238"/>
              <a:gd name="connsiteY45" fmla="*/ 94129 h 2678579"/>
              <a:gd name="connsiteX46" fmla="*/ 387350 w 1722238"/>
              <a:gd name="connsiteY46" fmla="*/ 119529 h 2678579"/>
              <a:gd name="connsiteX47" fmla="*/ 476250 w 1722238"/>
              <a:gd name="connsiteY47" fmla="*/ 157629 h 2678579"/>
              <a:gd name="connsiteX48" fmla="*/ 552450 w 1722238"/>
              <a:gd name="connsiteY48" fmla="*/ 202079 h 2678579"/>
              <a:gd name="connsiteX49" fmla="*/ 603250 w 1722238"/>
              <a:gd name="connsiteY49" fmla="*/ 233829 h 2678579"/>
              <a:gd name="connsiteX50" fmla="*/ 615950 w 1722238"/>
              <a:gd name="connsiteY50" fmla="*/ 233829 h 2678579"/>
              <a:gd name="connsiteX51" fmla="*/ 577850 w 1722238"/>
              <a:gd name="connsiteY51" fmla="*/ 189379 h 2678579"/>
              <a:gd name="connsiteX52" fmla="*/ 527050 w 1722238"/>
              <a:gd name="connsiteY52" fmla="*/ 151279 h 2678579"/>
              <a:gd name="connsiteX53" fmla="*/ 457200 w 1722238"/>
              <a:gd name="connsiteY53" fmla="*/ 119529 h 2678579"/>
              <a:gd name="connsiteX54" fmla="*/ 412750 w 1722238"/>
              <a:gd name="connsiteY54" fmla="*/ 113179 h 2678579"/>
              <a:gd name="connsiteX55" fmla="*/ 387350 w 1722238"/>
              <a:gd name="connsiteY55" fmla="*/ 94129 h 2678579"/>
              <a:gd name="connsiteX56" fmla="*/ 393700 w 1722238"/>
              <a:gd name="connsiteY56" fmla="*/ 75079 h 2678579"/>
              <a:gd name="connsiteX57" fmla="*/ 419100 w 1722238"/>
              <a:gd name="connsiteY57" fmla="*/ 56029 h 2678579"/>
              <a:gd name="connsiteX58" fmla="*/ 501650 w 1722238"/>
              <a:gd name="connsiteY58" fmla="*/ 68729 h 2678579"/>
              <a:gd name="connsiteX59" fmla="*/ 571500 w 1722238"/>
              <a:gd name="connsiteY59" fmla="*/ 94129 h 2678579"/>
              <a:gd name="connsiteX60" fmla="*/ 635000 w 1722238"/>
              <a:gd name="connsiteY60" fmla="*/ 138579 h 2678579"/>
              <a:gd name="connsiteX61" fmla="*/ 679450 w 1722238"/>
              <a:gd name="connsiteY61" fmla="*/ 176679 h 2678579"/>
              <a:gd name="connsiteX62" fmla="*/ 679450 w 1722238"/>
              <a:gd name="connsiteY62" fmla="*/ 163979 h 2678579"/>
              <a:gd name="connsiteX63" fmla="*/ 654050 w 1722238"/>
              <a:gd name="connsiteY63" fmla="*/ 113179 h 2678579"/>
              <a:gd name="connsiteX64" fmla="*/ 577850 w 1722238"/>
              <a:gd name="connsiteY64" fmla="*/ 75079 h 2678579"/>
              <a:gd name="connsiteX65" fmla="*/ 546100 w 1722238"/>
              <a:gd name="connsiteY65" fmla="*/ 36979 h 2678579"/>
              <a:gd name="connsiteX66" fmla="*/ 539750 w 1722238"/>
              <a:gd name="connsiteY66" fmla="*/ 11579 h 2678579"/>
              <a:gd name="connsiteX67" fmla="*/ 577850 w 1722238"/>
              <a:gd name="connsiteY67" fmla="*/ 5229 h 2678579"/>
              <a:gd name="connsiteX68" fmla="*/ 711200 w 1722238"/>
              <a:gd name="connsiteY68" fmla="*/ 87779 h 2678579"/>
              <a:gd name="connsiteX69" fmla="*/ 800100 w 1722238"/>
              <a:gd name="connsiteY69" fmla="*/ 176679 h 2678579"/>
              <a:gd name="connsiteX70" fmla="*/ 920750 w 1722238"/>
              <a:gd name="connsiteY70" fmla="*/ 310029 h 2678579"/>
              <a:gd name="connsiteX71" fmla="*/ 1054100 w 1722238"/>
              <a:gd name="connsiteY71" fmla="*/ 481479 h 2678579"/>
              <a:gd name="connsiteX72" fmla="*/ 1193800 w 1722238"/>
              <a:gd name="connsiteY72" fmla="*/ 621179 h 2678579"/>
              <a:gd name="connsiteX73" fmla="*/ 1308100 w 1722238"/>
              <a:gd name="connsiteY73" fmla="*/ 741829 h 2678579"/>
              <a:gd name="connsiteX74" fmla="*/ 1409700 w 1722238"/>
              <a:gd name="connsiteY74" fmla="*/ 881529 h 2678579"/>
              <a:gd name="connsiteX75" fmla="*/ 1479550 w 1722238"/>
              <a:gd name="connsiteY75" fmla="*/ 951379 h 2678579"/>
              <a:gd name="connsiteX76" fmla="*/ 1549400 w 1722238"/>
              <a:gd name="connsiteY76" fmla="*/ 1046629 h 2678579"/>
              <a:gd name="connsiteX77" fmla="*/ 1638300 w 1722238"/>
              <a:gd name="connsiteY77" fmla="*/ 1211729 h 2678579"/>
              <a:gd name="connsiteX78" fmla="*/ 1701800 w 1722238"/>
              <a:gd name="connsiteY78" fmla="*/ 1326029 h 2678579"/>
              <a:gd name="connsiteX79" fmla="*/ 1720850 w 1722238"/>
              <a:gd name="connsiteY79" fmla="*/ 1370479 h 2678579"/>
              <a:gd name="connsiteX80" fmla="*/ 1670050 w 1722238"/>
              <a:gd name="connsiteY80" fmla="*/ 1440329 h 2678579"/>
              <a:gd name="connsiteX81" fmla="*/ 1479550 w 1722238"/>
              <a:gd name="connsiteY81" fmla="*/ 1592729 h 2678579"/>
              <a:gd name="connsiteX82" fmla="*/ 1206500 w 1722238"/>
              <a:gd name="connsiteY82" fmla="*/ 1738779 h 2678579"/>
              <a:gd name="connsiteX83" fmla="*/ 933450 w 1722238"/>
              <a:gd name="connsiteY83" fmla="*/ 1840379 h 2678579"/>
              <a:gd name="connsiteX84" fmla="*/ 685800 w 1722238"/>
              <a:gd name="connsiteY84" fmla="*/ 1878479 h 2678579"/>
              <a:gd name="connsiteX85" fmla="*/ 546100 w 1722238"/>
              <a:gd name="connsiteY85" fmla="*/ 1941979 h 2678579"/>
              <a:gd name="connsiteX86" fmla="*/ 508000 w 1722238"/>
              <a:gd name="connsiteY86" fmla="*/ 2100729 h 2678579"/>
              <a:gd name="connsiteX87" fmla="*/ 508000 w 1722238"/>
              <a:gd name="connsiteY87" fmla="*/ 2221379 h 2678579"/>
              <a:gd name="connsiteX88" fmla="*/ 482600 w 1722238"/>
              <a:gd name="connsiteY88" fmla="*/ 2411879 h 2678579"/>
              <a:gd name="connsiteX89" fmla="*/ 412750 w 1722238"/>
              <a:gd name="connsiteY89" fmla="*/ 2494429 h 2678579"/>
              <a:gd name="connsiteX90" fmla="*/ 444500 w 1722238"/>
              <a:gd name="connsiteY90" fmla="*/ 2678579 h 2678579"/>
              <a:gd name="connsiteX0" fmla="*/ 0 w 1741288"/>
              <a:gd name="connsiteY0" fmla="*/ 1138704 h 2678579"/>
              <a:gd name="connsiteX1" fmla="*/ 31750 w 1741288"/>
              <a:gd name="connsiteY1" fmla="*/ 1275229 h 2678579"/>
              <a:gd name="connsiteX2" fmla="*/ 50800 w 1741288"/>
              <a:gd name="connsiteY2" fmla="*/ 1351429 h 2678579"/>
              <a:gd name="connsiteX3" fmla="*/ 234950 w 1741288"/>
              <a:gd name="connsiteY3" fmla="*/ 1414929 h 2678579"/>
              <a:gd name="connsiteX4" fmla="*/ 368300 w 1741288"/>
              <a:gd name="connsiteY4" fmla="*/ 1395879 h 2678579"/>
              <a:gd name="connsiteX5" fmla="*/ 501650 w 1741288"/>
              <a:gd name="connsiteY5" fmla="*/ 1364129 h 2678579"/>
              <a:gd name="connsiteX6" fmla="*/ 768350 w 1741288"/>
              <a:gd name="connsiteY6" fmla="*/ 1395879 h 2678579"/>
              <a:gd name="connsiteX7" fmla="*/ 844550 w 1741288"/>
              <a:gd name="connsiteY7" fmla="*/ 1383179 h 2678579"/>
              <a:gd name="connsiteX8" fmla="*/ 977900 w 1741288"/>
              <a:gd name="connsiteY8" fmla="*/ 1351429 h 2678579"/>
              <a:gd name="connsiteX9" fmla="*/ 1111250 w 1741288"/>
              <a:gd name="connsiteY9" fmla="*/ 1319679 h 2678579"/>
              <a:gd name="connsiteX10" fmla="*/ 1212850 w 1741288"/>
              <a:gd name="connsiteY10" fmla="*/ 1300629 h 2678579"/>
              <a:gd name="connsiteX11" fmla="*/ 1263650 w 1741288"/>
              <a:gd name="connsiteY11" fmla="*/ 1287929 h 2678579"/>
              <a:gd name="connsiteX12" fmla="*/ 1181100 w 1741288"/>
              <a:gd name="connsiteY12" fmla="*/ 1141879 h 2678579"/>
              <a:gd name="connsiteX13" fmla="*/ 1111250 w 1741288"/>
              <a:gd name="connsiteY13" fmla="*/ 983129 h 2678579"/>
              <a:gd name="connsiteX14" fmla="*/ 1022350 w 1741288"/>
              <a:gd name="connsiteY14" fmla="*/ 849779 h 2678579"/>
              <a:gd name="connsiteX15" fmla="*/ 901700 w 1741288"/>
              <a:gd name="connsiteY15" fmla="*/ 684679 h 2678579"/>
              <a:gd name="connsiteX16" fmla="*/ 812800 w 1741288"/>
              <a:gd name="connsiteY16" fmla="*/ 589429 h 2678579"/>
              <a:gd name="connsiteX17" fmla="*/ 692150 w 1741288"/>
              <a:gd name="connsiteY17" fmla="*/ 583079 h 2678579"/>
              <a:gd name="connsiteX18" fmla="*/ 641350 w 1741288"/>
              <a:gd name="connsiteY18" fmla="*/ 583079 h 2678579"/>
              <a:gd name="connsiteX19" fmla="*/ 565150 w 1741288"/>
              <a:gd name="connsiteY19" fmla="*/ 544979 h 2678579"/>
              <a:gd name="connsiteX20" fmla="*/ 514350 w 1741288"/>
              <a:gd name="connsiteY20" fmla="*/ 519579 h 2678579"/>
              <a:gd name="connsiteX21" fmla="*/ 463550 w 1741288"/>
              <a:gd name="connsiteY21" fmla="*/ 487829 h 2678579"/>
              <a:gd name="connsiteX22" fmla="*/ 419100 w 1741288"/>
              <a:gd name="connsiteY22" fmla="*/ 475129 h 2678579"/>
              <a:gd name="connsiteX23" fmla="*/ 406400 w 1741288"/>
              <a:gd name="connsiteY23" fmla="*/ 449729 h 2678579"/>
              <a:gd name="connsiteX24" fmla="*/ 438150 w 1741288"/>
              <a:gd name="connsiteY24" fmla="*/ 430679 h 2678579"/>
              <a:gd name="connsiteX25" fmla="*/ 514350 w 1741288"/>
              <a:gd name="connsiteY25" fmla="*/ 443379 h 2678579"/>
              <a:gd name="connsiteX26" fmla="*/ 558800 w 1741288"/>
              <a:gd name="connsiteY26" fmla="*/ 468779 h 2678579"/>
              <a:gd name="connsiteX27" fmla="*/ 590550 w 1741288"/>
              <a:gd name="connsiteY27" fmla="*/ 456079 h 2678579"/>
              <a:gd name="connsiteX28" fmla="*/ 590550 w 1741288"/>
              <a:gd name="connsiteY28" fmla="*/ 462429 h 2678579"/>
              <a:gd name="connsiteX29" fmla="*/ 558800 w 1741288"/>
              <a:gd name="connsiteY29" fmla="*/ 411629 h 2678579"/>
              <a:gd name="connsiteX30" fmla="*/ 488950 w 1741288"/>
              <a:gd name="connsiteY30" fmla="*/ 360829 h 2678579"/>
              <a:gd name="connsiteX31" fmla="*/ 393700 w 1741288"/>
              <a:gd name="connsiteY31" fmla="*/ 322729 h 2678579"/>
              <a:gd name="connsiteX32" fmla="*/ 336550 w 1741288"/>
              <a:gd name="connsiteY32" fmla="*/ 290979 h 2678579"/>
              <a:gd name="connsiteX33" fmla="*/ 317500 w 1741288"/>
              <a:gd name="connsiteY33" fmla="*/ 259229 h 2678579"/>
              <a:gd name="connsiteX34" fmla="*/ 317500 w 1741288"/>
              <a:gd name="connsiteY34" fmla="*/ 221129 h 2678579"/>
              <a:gd name="connsiteX35" fmla="*/ 349250 w 1741288"/>
              <a:gd name="connsiteY35" fmla="*/ 214779 h 2678579"/>
              <a:gd name="connsiteX36" fmla="*/ 387350 w 1741288"/>
              <a:gd name="connsiteY36" fmla="*/ 240179 h 2678579"/>
              <a:gd name="connsiteX37" fmla="*/ 469900 w 1741288"/>
              <a:gd name="connsiteY37" fmla="*/ 278279 h 2678579"/>
              <a:gd name="connsiteX38" fmla="*/ 527050 w 1741288"/>
              <a:gd name="connsiteY38" fmla="*/ 303679 h 2678579"/>
              <a:gd name="connsiteX39" fmla="*/ 565150 w 1741288"/>
              <a:gd name="connsiteY39" fmla="*/ 322729 h 2678579"/>
              <a:gd name="connsiteX40" fmla="*/ 514350 w 1741288"/>
              <a:gd name="connsiteY40" fmla="*/ 265579 h 2678579"/>
              <a:gd name="connsiteX41" fmla="*/ 444500 w 1741288"/>
              <a:gd name="connsiteY41" fmla="*/ 221129 h 2678579"/>
              <a:gd name="connsiteX42" fmla="*/ 368300 w 1741288"/>
              <a:gd name="connsiteY42" fmla="*/ 189379 h 2678579"/>
              <a:gd name="connsiteX43" fmla="*/ 336550 w 1741288"/>
              <a:gd name="connsiteY43" fmla="*/ 170329 h 2678579"/>
              <a:gd name="connsiteX44" fmla="*/ 304800 w 1741288"/>
              <a:gd name="connsiteY44" fmla="*/ 106829 h 2678579"/>
              <a:gd name="connsiteX45" fmla="*/ 349250 w 1741288"/>
              <a:gd name="connsiteY45" fmla="*/ 94129 h 2678579"/>
              <a:gd name="connsiteX46" fmla="*/ 406400 w 1741288"/>
              <a:gd name="connsiteY46" fmla="*/ 119529 h 2678579"/>
              <a:gd name="connsiteX47" fmla="*/ 495300 w 1741288"/>
              <a:gd name="connsiteY47" fmla="*/ 157629 h 2678579"/>
              <a:gd name="connsiteX48" fmla="*/ 571500 w 1741288"/>
              <a:gd name="connsiteY48" fmla="*/ 202079 h 2678579"/>
              <a:gd name="connsiteX49" fmla="*/ 622300 w 1741288"/>
              <a:gd name="connsiteY49" fmla="*/ 233829 h 2678579"/>
              <a:gd name="connsiteX50" fmla="*/ 635000 w 1741288"/>
              <a:gd name="connsiteY50" fmla="*/ 233829 h 2678579"/>
              <a:gd name="connsiteX51" fmla="*/ 596900 w 1741288"/>
              <a:gd name="connsiteY51" fmla="*/ 189379 h 2678579"/>
              <a:gd name="connsiteX52" fmla="*/ 546100 w 1741288"/>
              <a:gd name="connsiteY52" fmla="*/ 151279 h 2678579"/>
              <a:gd name="connsiteX53" fmla="*/ 476250 w 1741288"/>
              <a:gd name="connsiteY53" fmla="*/ 119529 h 2678579"/>
              <a:gd name="connsiteX54" fmla="*/ 431800 w 1741288"/>
              <a:gd name="connsiteY54" fmla="*/ 113179 h 2678579"/>
              <a:gd name="connsiteX55" fmla="*/ 406400 w 1741288"/>
              <a:gd name="connsiteY55" fmla="*/ 94129 h 2678579"/>
              <a:gd name="connsiteX56" fmla="*/ 412750 w 1741288"/>
              <a:gd name="connsiteY56" fmla="*/ 75079 h 2678579"/>
              <a:gd name="connsiteX57" fmla="*/ 438150 w 1741288"/>
              <a:gd name="connsiteY57" fmla="*/ 56029 h 2678579"/>
              <a:gd name="connsiteX58" fmla="*/ 520700 w 1741288"/>
              <a:gd name="connsiteY58" fmla="*/ 68729 h 2678579"/>
              <a:gd name="connsiteX59" fmla="*/ 590550 w 1741288"/>
              <a:gd name="connsiteY59" fmla="*/ 94129 h 2678579"/>
              <a:gd name="connsiteX60" fmla="*/ 654050 w 1741288"/>
              <a:gd name="connsiteY60" fmla="*/ 138579 h 2678579"/>
              <a:gd name="connsiteX61" fmla="*/ 698500 w 1741288"/>
              <a:gd name="connsiteY61" fmla="*/ 176679 h 2678579"/>
              <a:gd name="connsiteX62" fmla="*/ 698500 w 1741288"/>
              <a:gd name="connsiteY62" fmla="*/ 163979 h 2678579"/>
              <a:gd name="connsiteX63" fmla="*/ 673100 w 1741288"/>
              <a:gd name="connsiteY63" fmla="*/ 113179 h 2678579"/>
              <a:gd name="connsiteX64" fmla="*/ 596900 w 1741288"/>
              <a:gd name="connsiteY64" fmla="*/ 75079 h 2678579"/>
              <a:gd name="connsiteX65" fmla="*/ 565150 w 1741288"/>
              <a:gd name="connsiteY65" fmla="*/ 36979 h 2678579"/>
              <a:gd name="connsiteX66" fmla="*/ 558800 w 1741288"/>
              <a:gd name="connsiteY66" fmla="*/ 11579 h 2678579"/>
              <a:gd name="connsiteX67" fmla="*/ 596900 w 1741288"/>
              <a:gd name="connsiteY67" fmla="*/ 5229 h 2678579"/>
              <a:gd name="connsiteX68" fmla="*/ 730250 w 1741288"/>
              <a:gd name="connsiteY68" fmla="*/ 87779 h 2678579"/>
              <a:gd name="connsiteX69" fmla="*/ 819150 w 1741288"/>
              <a:gd name="connsiteY69" fmla="*/ 176679 h 2678579"/>
              <a:gd name="connsiteX70" fmla="*/ 939800 w 1741288"/>
              <a:gd name="connsiteY70" fmla="*/ 310029 h 2678579"/>
              <a:gd name="connsiteX71" fmla="*/ 1073150 w 1741288"/>
              <a:gd name="connsiteY71" fmla="*/ 481479 h 2678579"/>
              <a:gd name="connsiteX72" fmla="*/ 1212850 w 1741288"/>
              <a:gd name="connsiteY72" fmla="*/ 621179 h 2678579"/>
              <a:gd name="connsiteX73" fmla="*/ 1327150 w 1741288"/>
              <a:gd name="connsiteY73" fmla="*/ 741829 h 2678579"/>
              <a:gd name="connsiteX74" fmla="*/ 1428750 w 1741288"/>
              <a:gd name="connsiteY74" fmla="*/ 881529 h 2678579"/>
              <a:gd name="connsiteX75" fmla="*/ 1498600 w 1741288"/>
              <a:gd name="connsiteY75" fmla="*/ 951379 h 2678579"/>
              <a:gd name="connsiteX76" fmla="*/ 1568450 w 1741288"/>
              <a:gd name="connsiteY76" fmla="*/ 1046629 h 2678579"/>
              <a:gd name="connsiteX77" fmla="*/ 1657350 w 1741288"/>
              <a:gd name="connsiteY77" fmla="*/ 1211729 h 2678579"/>
              <a:gd name="connsiteX78" fmla="*/ 1720850 w 1741288"/>
              <a:gd name="connsiteY78" fmla="*/ 1326029 h 2678579"/>
              <a:gd name="connsiteX79" fmla="*/ 1739900 w 1741288"/>
              <a:gd name="connsiteY79" fmla="*/ 1370479 h 2678579"/>
              <a:gd name="connsiteX80" fmla="*/ 1689100 w 1741288"/>
              <a:gd name="connsiteY80" fmla="*/ 1440329 h 2678579"/>
              <a:gd name="connsiteX81" fmla="*/ 1498600 w 1741288"/>
              <a:gd name="connsiteY81" fmla="*/ 1592729 h 2678579"/>
              <a:gd name="connsiteX82" fmla="*/ 1225550 w 1741288"/>
              <a:gd name="connsiteY82" fmla="*/ 1738779 h 2678579"/>
              <a:gd name="connsiteX83" fmla="*/ 952500 w 1741288"/>
              <a:gd name="connsiteY83" fmla="*/ 1840379 h 2678579"/>
              <a:gd name="connsiteX84" fmla="*/ 704850 w 1741288"/>
              <a:gd name="connsiteY84" fmla="*/ 1878479 h 2678579"/>
              <a:gd name="connsiteX85" fmla="*/ 565150 w 1741288"/>
              <a:gd name="connsiteY85" fmla="*/ 1941979 h 2678579"/>
              <a:gd name="connsiteX86" fmla="*/ 527050 w 1741288"/>
              <a:gd name="connsiteY86" fmla="*/ 2100729 h 2678579"/>
              <a:gd name="connsiteX87" fmla="*/ 527050 w 1741288"/>
              <a:gd name="connsiteY87" fmla="*/ 2221379 h 2678579"/>
              <a:gd name="connsiteX88" fmla="*/ 501650 w 1741288"/>
              <a:gd name="connsiteY88" fmla="*/ 2411879 h 2678579"/>
              <a:gd name="connsiteX89" fmla="*/ 431800 w 1741288"/>
              <a:gd name="connsiteY89" fmla="*/ 2494429 h 2678579"/>
              <a:gd name="connsiteX90" fmla="*/ 463550 w 1741288"/>
              <a:gd name="connsiteY90" fmla="*/ 2678579 h 2678579"/>
              <a:gd name="connsiteX0" fmla="*/ 0 w 1741288"/>
              <a:gd name="connsiteY0" fmla="*/ 1138704 h 2678579"/>
              <a:gd name="connsiteX1" fmla="*/ 31750 w 1741288"/>
              <a:gd name="connsiteY1" fmla="*/ 1275229 h 2678579"/>
              <a:gd name="connsiteX2" fmla="*/ 50800 w 1741288"/>
              <a:gd name="connsiteY2" fmla="*/ 1351429 h 2678579"/>
              <a:gd name="connsiteX3" fmla="*/ 234950 w 1741288"/>
              <a:gd name="connsiteY3" fmla="*/ 1414929 h 2678579"/>
              <a:gd name="connsiteX4" fmla="*/ 368300 w 1741288"/>
              <a:gd name="connsiteY4" fmla="*/ 1395879 h 2678579"/>
              <a:gd name="connsiteX5" fmla="*/ 501650 w 1741288"/>
              <a:gd name="connsiteY5" fmla="*/ 1364129 h 2678579"/>
              <a:gd name="connsiteX6" fmla="*/ 768350 w 1741288"/>
              <a:gd name="connsiteY6" fmla="*/ 1395879 h 2678579"/>
              <a:gd name="connsiteX7" fmla="*/ 844550 w 1741288"/>
              <a:gd name="connsiteY7" fmla="*/ 1383179 h 2678579"/>
              <a:gd name="connsiteX8" fmla="*/ 977900 w 1741288"/>
              <a:gd name="connsiteY8" fmla="*/ 1351429 h 2678579"/>
              <a:gd name="connsiteX9" fmla="*/ 1111250 w 1741288"/>
              <a:gd name="connsiteY9" fmla="*/ 1319679 h 2678579"/>
              <a:gd name="connsiteX10" fmla="*/ 1212850 w 1741288"/>
              <a:gd name="connsiteY10" fmla="*/ 1300629 h 2678579"/>
              <a:gd name="connsiteX11" fmla="*/ 1263650 w 1741288"/>
              <a:gd name="connsiteY11" fmla="*/ 1287929 h 2678579"/>
              <a:gd name="connsiteX12" fmla="*/ 1181100 w 1741288"/>
              <a:gd name="connsiteY12" fmla="*/ 1141879 h 2678579"/>
              <a:gd name="connsiteX13" fmla="*/ 1111250 w 1741288"/>
              <a:gd name="connsiteY13" fmla="*/ 983129 h 2678579"/>
              <a:gd name="connsiteX14" fmla="*/ 1022350 w 1741288"/>
              <a:gd name="connsiteY14" fmla="*/ 849779 h 2678579"/>
              <a:gd name="connsiteX15" fmla="*/ 901700 w 1741288"/>
              <a:gd name="connsiteY15" fmla="*/ 684679 h 2678579"/>
              <a:gd name="connsiteX16" fmla="*/ 812800 w 1741288"/>
              <a:gd name="connsiteY16" fmla="*/ 589429 h 2678579"/>
              <a:gd name="connsiteX17" fmla="*/ 692150 w 1741288"/>
              <a:gd name="connsiteY17" fmla="*/ 583079 h 2678579"/>
              <a:gd name="connsiteX18" fmla="*/ 641350 w 1741288"/>
              <a:gd name="connsiteY18" fmla="*/ 583079 h 2678579"/>
              <a:gd name="connsiteX19" fmla="*/ 565150 w 1741288"/>
              <a:gd name="connsiteY19" fmla="*/ 544979 h 2678579"/>
              <a:gd name="connsiteX20" fmla="*/ 514350 w 1741288"/>
              <a:gd name="connsiteY20" fmla="*/ 519579 h 2678579"/>
              <a:gd name="connsiteX21" fmla="*/ 463550 w 1741288"/>
              <a:gd name="connsiteY21" fmla="*/ 487829 h 2678579"/>
              <a:gd name="connsiteX22" fmla="*/ 419100 w 1741288"/>
              <a:gd name="connsiteY22" fmla="*/ 475129 h 2678579"/>
              <a:gd name="connsiteX23" fmla="*/ 406400 w 1741288"/>
              <a:gd name="connsiteY23" fmla="*/ 449729 h 2678579"/>
              <a:gd name="connsiteX24" fmla="*/ 438150 w 1741288"/>
              <a:gd name="connsiteY24" fmla="*/ 430679 h 2678579"/>
              <a:gd name="connsiteX25" fmla="*/ 514350 w 1741288"/>
              <a:gd name="connsiteY25" fmla="*/ 443379 h 2678579"/>
              <a:gd name="connsiteX26" fmla="*/ 558800 w 1741288"/>
              <a:gd name="connsiteY26" fmla="*/ 468779 h 2678579"/>
              <a:gd name="connsiteX27" fmla="*/ 590550 w 1741288"/>
              <a:gd name="connsiteY27" fmla="*/ 456079 h 2678579"/>
              <a:gd name="connsiteX28" fmla="*/ 590550 w 1741288"/>
              <a:gd name="connsiteY28" fmla="*/ 462429 h 2678579"/>
              <a:gd name="connsiteX29" fmla="*/ 558800 w 1741288"/>
              <a:gd name="connsiteY29" fmla="*/ 411629 h 2678579"/>
              <a:gd name="connsiteX30" fmla="*/ 488950 w 1741288"/>
              <a:gd name="connsiteY30" fmla="*/ 360829 h 2678579"/>
              <a:gd name="connsiteX31" fmla="*/ 393700 w 1741288"/>
              <a:gd name="connsiteY31" fmla="*/ 322729 h 2678579"/>
              <a:gd name="connsiteX32" fmla="*/ 336550 w 1741288"/>
              <a:gd name="connsiteY32" fmla="*/ 290979 h 2678579"/>
              <a:gd name="connsiteX33" fmla="*/ 317500 w 1741288"/>
              <a:gd name="connsiteY33" fmla="*/ 259229 h 2678579"/>
              <a:gd name="connsiteX34" fmla="*/ 317500 w 1741288"/>
              <a:gd name="connsiteY34" fmla="*/ 221129 h 2678579"/>
              <a:gd name="connsiteX35" fmla="*/ 349250 w 1741288"/>
              <a:gd name="connsiteY35" fmla="*/ 214779 h 2678579"/>
              <a:gd name="connsiteX36" fmla="*/ 387350 w 1741288"/>
              <a:gd name="connsiteY36" fmla="*/ 240179 h 2678579"/>
              <a:gd name="connsiteX37" fmla="*/ 469900 w 1741288"/>
              <a:gd name="connsiteY37" fmla="*/ 278279 h 2678579"/>
              <a:gd name="connsiteX38" fmla="*/ 527050 w 1741288"/>
              <a:gd name="connsiteY38" fmla="*/ 303679 h 2678579"/>
              <a:gd name="connsiteX39" fmla="*/ 565150 w 1741288"/>
              <a:gd name="connsiteY39" fmla="*/ 322729 h 2678579"/>
              <a:gd name="connsiteX40" fmla="*/ 514350 w 1741288"/>
              <a:gd name="connsiteY40" fmla="*/ 265579 h 2678579"/>
              <a:gd name="connsiteX41" fmla="*/ 444500 w 1741288"/>
              <a:gd name="connsiteY41" fmla="*/ 221129 h 2678579"/>
              <a:gd name="connsiteX42" fmla="*/ 368300 w 1741288"/>
              <a:gd name="connsiteY42" fmla="*/ 189379 h 2678579"/>
              <a:gd name="connsiteX43" fmla="*/ 336550 w 1741288"/>
              <a:gd name="connsiteY43" fmla="*/ 170329 h 2678579"/>
              <a:gd name="connsiteX44" fmla="*/ 304800 w 1741288"/>
              <a:gd name="connsiteY44" fmla="*/ 106829 h 2678579"/>
              <a:gd name="connsiteX45" fmla="*/ 349250 w 1741288"/>
              <a:gd name="connsiteY45" fmla="*/ 94129 h 2678579"/>
              <a:gd name="connsiteX46" fmla="*/ 406400 w 1741288"/>
              <a:gd name="connsiteY46" fmla="*/ 119529 h 2678579"/>
              <a:gd name="connsiteX47" fmla="*/ 495300 w 1741288"/>
              <a:gd name="connsiteY47" fmla="*/ 157629 h 2678579"/>
              <a:gd name="connsiteX48" fmla="*/ 571500 w 1741288"/>
              <a:gd name="connsiteY48" fmla="*/ 202079 h 2678579"/>
              <a:gd name="connsiteX49" fmla="*/ 622300 w 1741288"/>
              <a:gd name="connsiteY49" fmla="*/ 233829 h 2678579"/>
              <a:gd name="connsiteX50" fmla="*/ 635000 w 1741288"/>
              <a:gd name="connsiteY50" fmla="*/ 233829 h 2678579"/>
              <a:gd name="connsiteX51" fmla="*/ 596900 w 1741288"/>
              <a:gd name="connsiteY51" fmla="*/ 189379 h 2678579"/>
              <a:gd name="connsiteX52" fmla="*/ 546100 w 1741288"/>
              <a:gd name="connsiteY52" fmla="*/ 151279 h 2678579"/>
              <a:gd name="connsiteX53" fmla="*/ 476250 w 1741288"/>
              <a:gd name="connsiteY53" fmla="*/ 119529 h 2678579"/>
              <a:gd name="connsiteX54" fmla="*/ 431800 w 1741288"/>
              <a:gd name="connsiteY54" fmla="*/ 113179 h 2678579"/>
              <a:gd name="connsiteX55" fmla="*/ 406400 w 1741288"/>
              <a:gd name="connsiteY55" fmla="*/ 94129 h 2678579"/>
              <a:gd name="connsiteX56" fmla="*/ 412750 w 1741288"/>
              <a:gd name="connsiteY56" fmla="*/ 75079 h 2678579"/>
              <a:gd name="connsiteX57" fmla="*/ 438150 w 1741288"/>
              <a:gd name="connsiteY57" fmla="*/ 56029 h 2678579"/>
              <a:gd name="connsiteX58" fmla="*/ 520700 w 1741288"/>
              <a:gd name="connsiteY58" fmla="*/ 68729 h 2678579"/>
              <a:gd name="connsiteX59" fmla="*/ 590550 w 1741288"/>
              <a:gd name="connsiteY59" fmla="*/ 94129 h 2678579"/>
              <a:gd name="connsiteX60" fmla="*/ 654050 w 1741288"/>
              <a:gd name="connsiteY60" fmla="*/ 138579 h 2678579"/>
              <a:gd name="connsiteX61" fmla="*/ 698500 w 1741288"/>
              <a:gd name="connsiteY61" fmla="*/ 176679 h 2678579"/>
              <a:gd name="connsiteX62" fmla="*/ 698500 w 1741288"/>
              <a:gd name="connsiteY62" fmla="*/ 163979 h 2678579"/>
              <a:gd name="connsiteX63" fmla="*/ 673100 w 1741288"/>
              <a:gd name="connsiteY63" fmla="*/ 113179 h 2678579"/>
              <a:gd name="connsiteX64" fmla="*/ 596900 w 1741288"/>
              <a:gd name="connsiteY64" fmla="*/ 75079 h 2678579"/>
              <a:gd name="connsiteX65" fmla="*/ 565150 w 1741288"/>
              <a:gd name="connsiteY65" fmla="*/ 36979 h 2678579"/>
              <a:gd name="connsiteX66" fmla="*/ 558800 w 1741288"/>
              <a:gd name="connsiteY66" fmla="*/ 11579 h 2678579"/>
              <a:gd name="connsiteX67" fmla="*/ 596900 w 1741288"/>
              <a:gd name="connsiteY67" fmla="*/ 5229 h 2678579"/>
              <a:gd name="connsiteX68" fmla="*/ 730250 w 1741288"/>
              <a:gd name="connsiteY68" fmla="*/ 87779 h 2678579"/>
              <a:gd name="connsiteX69" fmla="*/ 819150 w 1741288"/>
              <a:gd name="connsiteY69" fmla="*/ 176679 h 2678579"/>
              <a:gd name="connsiteX70" fmla="*/ 939800 w 1741288"/>
              <a:gd name="connsiteY70" fmla="*/ 310029 h 2678579"/>
              <a:gd name="connsiteX71" fmla="*/ 1073150 w 1741288"/>
              <a:gd name="connsiteY71" fmla="*/ 481479 h 2678579"/>
              <a:gd name="connsiteX72" fmla="*/ 1212850 w 1741288"/>
              <a:gd name="connsiteY72" fmla="*/ 621179 h 2678579"/>
              <a:gd name="connsiteX73" fmla="*/ 1327150 w 1741288"/>
              <a:gd name="connsiteY73" fmla="*/ 741829 h 2678579"/>
              <a:gd name="connsiteX74" fmla="*/ 1428750 w 1741288"/>
              <a:gd name="connsiteY74" fmla="*/ 881529 h 2678579"/>
              <a:gd name="connsiteX75" fmla="*/ 1498600 w 1741288"/>
              <a:gd name="connsiteY75" fmla="*/ 951379 h 2678579"/>
              <a:gd name="connsiteX76" fmla="*/ 1568450 w 1741288"/>
              <a:gd name="connsiteY76" fmla="*/ 1046629 h 2678579"/>
              <a:gd name="connsiteX77" fmla="*/ 1657350 w 1741288"/>
              <a:gd name="connsiteY77" fmla="*/ 1211729 h 2678579"/>
              <a:gd name="connsiteX78" fmla="*/ 1720850 w 1741288"/>
              <a:gd name="connsiteY78" fmla="*/ 1326029 h 2678579"/>
              <a:gd name="connsiteX79" fmla="*/ 1739900 w 1741288"/>
              <a:gd name="connsiteY79" fmla="*/ 1370479 h 2678579"/>
              <a:gd name="connsiteX80" fmla="*/ 1689100 w 1741288"/>
              <a:gd name="connsiteY80" fmla="*/ 1440329 h 2678579"/>
              <a:gd name="connsiteX81" fmla="*/ 1498600 w 1741288"/>
              <a:gd name="connsiteY81" fmla="*/ 1592729 h 2678579"/>
              <a:gd name="connsiteX82" fmla="*/ 1225550 w 1741288"/>
              <a:gd name="connsiteY82" fmla="*/ 1738779 h 2678579"/>
              <a:gd name="connsiteX83" fmla="*/ 952500 w 1741288"/>
              <a:gd name="connsiteY83" fmla="*/ 1840379 h 2678579"/>
              <a:gd name="connsiteX84" fmla="*/ 704850 w 1741288"/>
              <a:gd name="connsiteY84" fmla="*/ 1878479 h 2678579"/>
              <a:gd name="connsiteX85" fmla="*/ 565150 w 1741288"/>
              <a:gd name="connsiteY85" fmla="*/ 1941979 h 2678579"/>
              <a:gd name="connsiteX86" fmla="*/ 527050 w 1741288"/>
              <a:gd name="connsiteY86" fmla="*/ 2100729 h 2678579"/>
              <a:gd name="connsiteX87" fmla="*/ 527050 w 1741288"/>
              <a:gd name="connsiteY87" fmla="*/ 2221379 h 2678579"/>
              <a:gd name="connsiteX88" fmla="*/ 501650 w 1741288"/>
              <a:gd name="connsiteY88" fmla="*/ 2411879 h 2678579"/>
              <a:gd name="connsiteX89" fmla="*/ 488950 w 1741288"/>
              <a:gd name="connsiteY89" fmla="*/ 2503954 h 2678579"/>
              <a:gd name="connsiteX90" fmla="*/ 463550 w 1741288"/>
              <a:gd name="connsiteY90" fmla="*/ 2678579 h 2678579"/>
              <a:gd name="connsiteX0" fmla="*/ 0 w 1741288"/>
              <a:gd name="connsiteY0" fmla="*/ 1138704 h 2503954"/>
              <a:gd name="connsiteX1" fmla="*/ 31750 w 1741288"/>
              <a:gd name="connsiteY1" fmla="*/ 1275229 h 2503954"/>
              <a:gd name="connsiteX2" fmla="*/ 50800 w 1741288"/>
              <a:gd name="connsiteY2" fmla="*/ 1351429 h 2503954"/>
              <a:gd name="connsiteX3" fmla="*/ 234950 w 1741288"/>
              <a:gd name="connsiteY3" fmla="*/ 1414929 h 2503954"/>
              <a:gd name="connsiteX4" fmla="*/ 368300 w 1741288"/>
              <a:gd name="connsiteY4" fmla="*/ 1395879 h 2503954"/>
              <a:gd name="connsiteX5" fmla="*/ 501650 w 1741288"/>
              <a:gd name="connsiteY5" fmla="*/ 1364129 h 2503954"/>
              <a:gd name="connsiteX6" fmla="*/ 768350 w 1741288"/>
              <a:gd name="connsiteY6" fmla="*/ 1395879 h 2503954"/>
              <a:gd name="connsiteX7" fmla="*/ 844550 w 1741288"/>
              <a:gd name="connsiteY7" fmla="*/ 1383179 h 2503954"/>
              <a:gd name="connsiteX8" fmla="*/ 977900 w 1741288"/>
              <a:gd name="connsiteY8" fmla="*/ 1351429 h 2503954"/>
              <a:gd name="connsiteX9" fmla="*/ 1111250 w 1741288"/>
              <a:gd name="connsiteY9" fmla="*/ 1319679 h 2503954"/>
              <a:gd name="connsiteX10" fmla="*/ 1212850 w 1741288"/>
              <a:gd name="connsiteY10" fmla="*/ 1300629 h 2503954"/>
              <a:gd name="connsiteX11" fmla="*/ 1263650 w 1741288"/>
              <a:gd name="connsiteY11" fmla="*/ 1287929 h 2503954"/>
              <a:gd name="connsiteX12" fmla="*/ 1181100 w 1741288"/>
              <a:gd name="connsiteY12" fmla="*/ 1141879 h 2503954"/>
              <a:gd name="connsiteX13" fmla="*/ 1111250 w 1741288"/>
              <a:gd name="connsiteY13" fmla="*/ 983129 h 2503954"/>
              <a:gd name="connsiteX14" fmla="*/ 1022350 w 1741288"/>
              <a:gd name="connsiteY14" fmla="*/ 849779 h 2503954"/>
              <a:gd name="connsiteX15" fmla="*/ 901700 w 1741288"/>
              <a:gd name="connsiteY15" fmla="*/ 684679 h 2503954"/>
              <a:gd name="connsiteX16" fmla="*/ 812800 w 1741288"/>
              <a:gd name="connsiteY16" fmla="*/ 589429 h 2503954"/>
              <a:gd name="connsiteX17" fmla="*/ 692150 w 1741288"/>
              <a:gd name="connsiteY17" fmla="*/ 583079 h 2503954"/>
              <a:gd name="connsiteX18" fmla="*/ 641350 w 1741288"/>
              <a:gd name="connsiteY18" fmla="*/ 583079 h 2503954"/>
              <a:gd name="connsiteX19" fmla="*/ 565150 w 1741288"/>
              <a:gd name="connsiteY19" fmla="*/ 544979 h 2503954"/>
              <a:gd name="connsiteX20" fmla="*/ 514350 w 1741288"/>
              <a:gd name="connsiteY20" fmla="*/ 519579 h 2503954"/>
              <a:gd name="connsiteX21" fmla="*/ 463550 w 1741288"/>
              <a:gd name="connsiteY21" fmla="*/ 487829 h 2503954"/>
              <a:gd name="connsiteX22" fmla="*/ 419100 w 1741288"/>
              <a:gd name="connsiteY22" fmla="*/ 475129 h 2503954"/>
              <a:gd name="connsiteX23" fmla="*/ 406400 w 1741288"/>
              <a:gd name="connsiteY23" fmla="*/ 449729 h 2503954"/>
              <a:gd name="connsiteX24" fmla="*/ 438150 w 1741288"/>
              <a:gd name="connsiteY24" fmla="*/ 430679 h 2503954"/>
              <a:gd name="connsiteX25" fmla="*/ 514350 w 1741288"/>
              <a:gd name="connsiteY25" fmla="*/ 443379 h 2503954"/>
              <a:gd name="connsiteX26" fmla="*/ 558800 w 1741288"/>
              <a:gd name="connsiteY26" fmla="*/ 468779 h 2503954"/>
              <a:gd name="connsiteX27" fmla="*/ 590550 w 1741288"/>
              <a:gd name="connsiteY27" fmla="*/ 456079 h 2503954"/>
              <a:gd name="connsiteX28" fmla="*/ 590550 w 1741288"/>
              <a:gd name="connsiteY28" fmla="*/ 462429 h 2503954"/>
              <a:gd name="connsiteX29" fmla="*/ 558800 w 1741288"/>
              <a:gd name="connsiteY29" fmla="*/ 411629 h 2503954"/>
              <a:gd name="connsiteX30" fmla="*/ 488950 w 1741288"/>
              <a:gd name="connsiteY30" fmla="*/ 360829 h 2503954"/>
              <a:gd name="connsiteX31" fmla="*/ 393700 w 1741288"/>
              <a:gd name="connsiteY31" fmla="*/ 322729 h 2503954"/>
              <a:gd name="connsiteX32" fmla="*/ 336550 w 1741288"/>
              <a:gd name="connsiteY32" fmla="*/ 290979 h 2503954"/>
              <a:gd name="connsiteX33" fmla="*/ 317500 w 1741288"/>
              <a:gd name="connsiteY33" fmla="*/ 259229 h 2503954"/>
              <a:gd name="connsiteX34" fmla="*/ 317500 w 1741288"/>
              <a:gd name="connsiteY34" fmla="*/ 221129 h 2503954"/>
              <a:gd name="connsiteX35" fmla="*/ 349250 w 1741288"/>
              <a:gd name="connsiteY35" fmla="*/ 214779 h 2503954"/>
              <a:gd name="connsiteX36" fmla="*/ 387350 w 1741288"/>
              <a:gd name="connsiteY36" fmla="*/ 240179 h 2503954"/>
              <a:gd name="connsiteX37" fmla="*/ 469900 w 1741288"/>
              <a:gd name="connsiteY37" fmla="*/ 278279 h 2503954"/>
              <a:gd name="connsiteX38" fmla="*/ 527050 w 1741288"/>
              <a:gd name="connsiteY38" fmla="*/ 303679 h 2503954"/>
              <a:gd name="connsiteX39" fmla="*/ 565150 w 1741288"/>
              <a:gd name="connsiteY39" fmla="*/ 322729 h 2503954"/>
              <a:gd name="connsiteX40" fmla="*/ 514350 w 1741288"/>
              <a:gd name="connsiteY40" fmla="*/ 265579 h 2503954"/>
              <a:gd name="connsiteX41" fmla="*/ 444500 w 1741288"/>
              <a:gd name="connsiteY41" fmla="*/ 221129 h 2503954"/>
              <a:gd name="connsiteX42" fmla="*/ 368300 w 1741288"/>
              <a:gd name="connsiteY42" fmla="*/ 189379 h 2503954"/>
              <a:gd name="connsiteX43" fmla="*/ 336550 w 1741288"/>
              <a:gd name="connsiteY43" fmla="*/ 170329 h 2503954"/>
              <a:gd name="connsiteX44" fmla="*/ 304800 w 1741288"/>
              <a:gd name="connsiteY44" fmla="*/ 106829 h 2503954"/>
              <a:gd name="connsiteX45" fmla="*/ 349250 w 1741288"/>
              <a:gd name="connsiteY45" fmla="*/ 94129 h 2503954"/>
              <a:gd name="connsiteX46" fmla="*/ 406400 w 1741288"/>
              <a:gd name="connsiteY46" fmla="*/ 119529 h 2503954"/>
              <a:gd name="connsiteX47" fmla="*/ 495300 w 1741288"/>
              <a:gd name="connsiteY47" fmla="*/ 157629 h 2503954"/>
              <a:gd name="connsiteX48" fmla="*/ 571500 w 1741288"/>
              <a:gd name="connsiteY48" fmla="*/ 202079 h 2503954"/>
              <a:gd name="connsiteX49" fmla="*/ 622300 w 1741288"/>
              <a:gd name="connsiteY49" fmla="*/ 233829 h 2503954"/>
              <a:gd name="connsiteX50" fmla="*/ 635000 w 1741288"/>
              <a:gd name="connsiteY50" fmla="*/ 233829 h 2503954"/>
              <a:gd name="connsiteX51" fmla="*/ 596900 w 1741288"/>
              <a:gd name="connsiteY51" fmla="*/ 189379 h 2503954"/>
              <a:gd name="connsiteX52" fmla="*/ 546100 w 1741288"/>
              <a:gd name="connsiteY52" fmla="*/ 151279 h 2503954"/>
              <a:gd name="connsiteX53" fmla="*/ 476250 w 1741288"/>
              <a:gd name="connsiteY53" fmla="*/ 119529 h 2503954"/>
              <a:gd name="connsiteX54" fmla="*/ 431800 w 1741288"/>
              <a:gd name="connsiteY54" fmla="*/ 113179 h 2503954"/>
              <a:gd name="connsiteX55" fmla="*/ 406400 w 1741288"/>
              <a:gd name="connsiteY55" fmla="*/ 94129 h 2503954"/>
              <a:gd name="connsiteX56" fmla="*/ 412750 w 1741288"/>
              <a:gd name="connsiteY56" fmla="*/ 75079 h 2503954"/>
              <a:gd name="connsiteX57" fmla="*/ 438150 w 1741288"/>
              <a:gd name="connsiteY57" fmla="*/ 56029 h 2503954"/>
              <a:gd name="connsiteX58" fmla="*/ 520700 w 1741288"/>
              <a:gd name="connsiteY58" fmla="*/ 68729 h 2503954"/>
              <a:gd name="connsiteX59" fmla="*/ 590550 w 1741288"/>
              <a:gd name="connsiteY59" fmla="*/ 94129 h 2503954"/>
              <a:gd name="connsiteX60" fmla="*/ 654050 w 1741288"/>
              <a:gd name="connsiteY60" fmla="*/ 138579 h 2503954"/>
              <a:gd name="connsiteX61" fmla="*/ 698500 w 1741288"/>
              <a:gd name="connsiteY61" fmla="*/ 176679 h 2503954"/>
              <a:gd name="connsiteX62" fmla="*/ 698500 w 1741288"/>
              <a:gd name="connsiteY62" fmla="*/ 163979 h 2503954"/>
              <a:gd name="connsiteX63" fmla="*/ 673100 w 1741288"/>
              <a:gd name="connsiteY63" fmla="*/ 113179 h 2503954"/>
              <a:gd name="connsiteX64" fmla="*/ 596900 w 1741288"/>
              <a:gd name="connsiteY64" fmla="*/ 75079 h 2503954"/>
              <a:gd name="connsiteX65" fmla="*/ 565150 w 1741288"/>
              <a:gd name="connsiteY65" fmla="*/ 36979 h 2503954"/>
              <a:gd name="connsiteX66" fmla="*/ 558800 w 1741288"/>
              <a:gd name="connsiteY66" fmla="*/ 11579 h 2503954"/>
              <a:gd name="connsiteX67" fmla="*/ 596900 w 1741288"/>
              <a:gd name="connsiteY67" fmla="*/ 5229 h 2503954"/>
              <a:gd name="connsiteX68" fmla="*/ 730250 w 1741288"/>
              <a:gd name="connsiteY68" fmla="*/ 87779 h 2503954"/>
              <a:gd name="connsiteX69" fmla="*/ 819150 w 1741288"/>
              <a:gd name="connsiteY69" fmla="*/ 176679 h 2503954"/>
              <a:gd name="connsiteX70" fmla="*/ 939800 w 1741288"/>
              <a:gd name="connsiteY70" fmla="*/ 310029 h 2503954"/>
              <a:gd name="connsiteX71" fmla="*/ 1073150 w 1741288"/>
              <a:gd name="connsiteY71" fmla="*/ 481479 h 2503954"/>
              <a:gd name="connsiteX72" fmla="*/ 1212850 w 1741288"/>
              <a:gd name="connsiteY72" fmla="*/ 621179 h 2503954"/>
              <a:gd name="connsiteX73" fmla="*/ 1327150 w 1741288"/>
              <a:gd name="connsiteY73" fmla="*/ 741829 h 2503954"/>
              <a:gd name="connsiteX74" fmla="*/ 1428750 w 1741288"/>
              <a:gd name="connsiteY74" fmla="*/ 881529 h 2503954"/>
              <a:gd name="connsiteX75" fmla="*/ 1498600 w 1741288"/>
              <a:gd name="connsiteY75" fmla="*/ 951379 h 2503954"/>
              <a:gd name="connsiteX76" fmla="*/ 1568450 w 1741288"/>
              <a:gd name="connsiteY76" fmla="*/ 1046629 h 2503954"/>
              <a:gd name="connsiteX77" fmla="*/ 1657350 w 1741288"/>
              <a:gd name="connsiteY77" fmla="*/ 1211729 h 2503954"/>
              <a:gd name="connsiteX78" fmla="*/ 1720850 w 1741288"/>
              <a:gd name="connsiteY78" fmla="*/ 1326029 h 2503954"/>
              <a:gd name="connsiteX79" fmla="*/ 1739900 w 1741288"/>
              <a:gd name="connsiteY79" fmla="*/ 1370479 h 2503954"/>
              <a:gd name="connsiteX80" fmla="*/ 1689100 w 1741288"/>
              <a:gd name="connsiteY80" fmla="*/ 1440329 h 2503954"/>
              <a:gd name="connsiteX81" fmla="*/ 1498600 w 1741288"/>
              <a:gd name="connsiteY81" fmla="*/ 1592729 h 2503954"/>
              <a:gd name="connsiteX82" fmla="*/ 1225550 w 1741288"/>
              <a:gd name="connsiteY82" fmla="*/ 1738779 h 2503954"/>
              <a:gd name="connsiteX83" fmla="*/ 952500 w 1741288"/>
              <a:gd name="connsiteY83" fmla="*/ 1840379 h 2503954"/>
              <a:gd name="connsiteX84" fmla="*/ 704850 w 1741288"/>
              <a:gd name="connsiteY84" fmla="*/ 1878479 h 2503954"/>
              <a:gd name="connsiteX85" fmla="*/ 565150 w 1741288"/>
              <a:gd name="connsiteY85" fmla="*/ 1941979 h 2503954"/>
              <a:gd name="connsiteX86" fmla="*/ 527050 w 1741288"/>
              <a:gd name="connsiteY86" fmla="*/ 2100729 h 2503954"/>
              <a:gd name="connsiteX87" fmla="*/ 527050 w 1741288"/>
              <a:gd name="connsiteY87" fmla="*/ 2221379 h 2503954"/>
              <a:gd name="connsiteX88" fmla="*/ 501650 w 1741288"/>
              <a:gd name="connsiteY88" fmla="*/ 2411879 h 2503954"/>
              <a:gd name="connsiteX89" fmla="*/ 488950 w 1741288"/>
              <a:gd name="connsiteY89" fmla="*/ 2503954 h 2503954"/>
              <a:gd name="connsiteX0" fmla="*/ 0 w 1741288"/>
              <a:gd name="connsiteY0" fmla="*/ 1138704 h 2411879"/>
              <a:gd name="connsiteX1" fmla="*/ 31750 w 1741288"/>
              <a:gd name="connsiteY1" fmla="*/ 1275229 h 2411879"/>
              <a:gd name="connsiteX2" fmla="*/ 50800 w 1741288"/>
              <a:gd name="connsiteY2" fmla="*/ 1351429 h 2411879"/>
              <a:gd name="connsiteX3" fmla="*/ 234950 w 1741288"/>
              <a:gd name="connsiteY3" fmla="*/ 1414929 h 2411879"/>
              <a:gd name="connsiteX4" fmla="*/ 368300 w 1741288"/>
              <a:gd name="connsiteY4" fmla="*/ 1395879 h 2411879"/>
              <a:gd name="connsiteX5" fmla="*/ 501650 w 1741288"/>
              <a:gd name="connsiteY5" fmla="*/ 1364129 h 2411879"/>
              <a:gd name="connsiteX6" fmla="*/ 768350 w 1741288"/>
              <a:gd name="connsiteY6" fmla="*/ 1395879 h 2411879"/>
              <a:gd name="connsiteX7" fmla="*/ 844550 w 1741288"/>
              <a:gd name="connsiteY7" fmla="*/ 1383179 h 2411879"/>
              <a:gd name="connsiteX8" fmla="*/ 977900 w 1741288"/>
              <a:gd name="connsiteY8" fmla="*/ 1351429 h 2411879"/>
              <a:gd name="connsiteX9" fmla="*/ 1111250 w 1741288"/>
              <a:gd name="connsiteY9" fmla="*/ 1319679 h 2411879"/>
              <a:gd name="connsiteX10" fmla="*/ 1212850 w 1741288"/>
              <a:gd name="connsiteY10" fmla="*/ 1300629 h 2411879"/>
              <a:gd name="connsiteX11" fmla="*/ 1263650 w 1741288"/>
              <a:gd name="connsiteY11" fmla="*/ 1287929 h 2411879"/>
              <a:gd name="connsiteX12" fmla="*/ 1181100 w 1741288"/>
              <a:gd name="connsiteY12" fmla="*/ 1141879 h 2411879"/>
              <a:gd name="connsiteX13" fmla="*/ 1111250 w 1741288"/>
              <a:gd name="connsiteY13" fmla="*/ 983129 h 2411879"/>
              <a:gd name="connsiteX14" fmla="*/ 1022350 w 1741288"/>
              <a:gd name="connsiteY14" fmla="*/ 849779 h 2411879"/>
              <a:gd name="connsiteX15" fmla="*/ 901700 w 1741288"/>
              <a:gd name="connsiteY15" fmla="*/ 684679 h 2411879"/>
              <a:gd name="connsiteX16" fmla="*/ 812800 w 1741288"/>
              <a:gd name="connsiteY16" fmla="*/ 589429 h 2411879"/>
              <a:gd name="connsiteX17" fmla="*/ 692150 w 1741288"/>
              <a:gd name="connsiteY17" fmla="*/ 583079 h 2411879"/>
              <a:gd name="connsiteX18" fmla="*/ 641350 w 1741288"/>
              <a:gd name="connsiteY18" fmla="*/ 583079 h 2411879"/>
              <a:gd name="connsiteX19" fmla="*/ 565150 w 1741288"/>
              <a:gd name="connsiteY19" fmla="*/ 544979 h 2411879"/>
              <a:gd name="connsiteX20" fmla="*/ 514350 w 1741288"/>
              <a:gd name="connsiteY20" fmla="*/ 519579 h 2411879"/>
              <a:gd name="connsiteX21" fmla="*/ 463550 w 1741288"/>
              <a:gd name="connsiteY21" fmla="*/ 487829 h 2411879"/>
              <a:gd name="connsiteX22" fmla="*/ 419100 w 1741288"/>
              <a:gd name="connsiteY22" fmla="*/ 475129 h 2411879"/>
              <a:gd name="connsiteX23" fmla="*/ 406400 w 1741288"/>
              <a:gd name="connsiteY23" fmla="*/ 449729 h 2411879"/>
              <a:gd name="connsiteX24" fmla="*/ 438150 w 1741288"/>
              <a:gd name="connsiteY24" fmla="*/ 430679 h 2411879"/>
              <a:gd name="connsiteX25" fmla="*/ 514350 w 1741288"/>
              <a:gd name="connsiteY25" fmla="*/ 443379 h 2411879"/>
              <a:gd name="connsiteX26" fmla="*/ 558800 w 1741288"/>
              <a:gd name="connsiteY26" fmla="*/ 468779 h 2411879"/>
              <a:gd name="connsiteX27" fmla="*/ 590550 w 1741288"/>
              <a:gd name="connsiteY27" fmla="*/ 456079 h 2411879"/>
              <a:gd name="connsiteX28" fmla="*/ 590550 w 1741288"/>
              <a:gd name="connsiteY28" fmla="*/ 462429 h 2411879"/>
              <a:gd name="connsiteX29" fmla="*/ 558800 w 1741288"/>
              <a:gd name="connsiteY29" fmla="*/ 411629 h 2411879"/>
              <a:gd name="connsiteX30" fmla="*/ 488950 w 1741288"/>
              <a:gd name="connsiteY30" fmla="*/ 360829 h 2411879"/>
              <a:gd name="connsiteX31" fmla="*/ 393700 w 1741288"/>
              <a:gd name="connsiteY31" fmla="*/ 322729 h 2411879"/>
              <a:gd name="connsiteX32" fmla="*/ 336550 w 1741288"/>
              <a:gd name="connsiteY32" fmla="*/ 290979 h 2411879"/>
              <a:gd name="connsiteX33" fmla="*/ 317500 w 1741288"/>
              <a:gd name="connsiteY33" fmla="*/ 259229 h 2411879"/>
              <a:gd name="connsiteX34" fmla="*/ 317500 w 1741288"/>
              <a:gd name="connsiteY34" fmla="*/ 221129 h 2411879"/>
              <a:gd name="connsiteX35" fmla="*/ 349250 w 1741288"/>
              <a:gd name="connsiteY35" fmla="*/ 214779 h 2411879"/>
              <a:gd name="connsiteX36" fmla="*/ 387350 w 1741288"/>
              <a:gd name="connsiteY36" fmla="*/ 240179 h 2411879"/>
              <a:gd name="connsiteX37" fmla="*/ 469900 w 1741288"/>
              <a:gd name="connsiteY37" fmla="*/ 278279 h 2411879"/>
              <a:gd name="connsiteX38" fmla="*/ 527050 w 1741288"/>
              <a:gd name="connsiteY38" fmla="*/ 303679 h 2411879"/>
              <a:gd name="connsiteX39" fmla="*/ 565150 w 1741288"/>
              <a:gd name="connsiteY39" fmla="*/ 322729 h 2411879"/>
              <a:gd name="connsiteX40" fmla="*/ 514350 w 1741288"/>
              <a:gd name="connsiteY40" fmla="*/ 265579 h 2411879"/>
              <a:gd name="connsiteX41" fmla="*/ 444500 w 1741288"/>
              <a:gd name="connsiteY41" fmla="*/ 221129 h 2411879"/>
              <a:gd name="connsiteX42" fmla="*/ 368300 w 1741288"/>
              <a:gd name="connsiteY42" fmla="*/ 189379 h 2411879"/>
              <a:gd name="connsiteX43" fmla="*/ 336550 w 1741288"/>
              <a:gd name="connsiteY43" fmla="*/ 170329 h 2411879"/>
              <a:gd name="connsiteX44" fmla="*/ 304800 w 1741288"/>
              <a:gd name="connsiteY44" fmla="*/ 106829 h 2411879"/>
              <a:gd name="connsiteX45" fmla="*/ 349250 w 1741288"/>
              <a:gd name="connsiteY45" fmla="*/ 94129 h 2411879"/>
              <a:gd name="connsiteX46" fmla="*/ 406400 w 1741288"/>
              <a:gd name="connsiteY46" fmla="*/ 119529 h 2411879"/>
              <a:gd name="connsiteX47" fmla="*/ 495300 w 1741288"/>
              <a:gd name="connsiteY47" fmla="*/ 157629 h 2411879"/>
              <a:gd name="connsiteX48" fmla="*/ 571500 w 1741288"/>
              <a:gd name="connsiteY48" fmla="*/ 202079 h 2411879"/>
              <a:gd name="connsiteX49" fmla="*/ 622300 w 1741288"/>
              <a:gd name="connsiteY49" fmla="*/ 233829 h 2411879"/>
              <a:gd name="connsiteX50" fmla="*/ 635000 w 1741288"/>
              <a:gd name="connsiteY50" fmla="*/ 233829 h 2411879"/>
              <a:gd name="connsiteX51" fmla="*/ 596900 w 1741288"/>
              <a:gd name="connsiteY51" fmla="*/ 189379 h 2411879"/>
              <a:gd name="connsiteX52" fmla="*/ 546100 w 1741288"/>
              <a:gd name="connsiteY52" fmla="*/ 151279 h 2411879"/>
              <a:gd name="connsiteX53" fmla="*/ 476250 w 1741288"/>
              <a:gd name="connsiteY53" fmla="*/ 119529 h 2411879"/>
              <a:gd name="connsiteX54" fmla="*/ 431800 w 1741288"/>
              <a:gd name="connsiteY54" fmla="*/ 113179 h 2411879"/>
              <a:gd name="connsiteX55" fmla="*/ 406400 w 1741288"/>
              <a:gd name="connsiteY55" fmla="*/ 94129 h 2411879"/>
              <a:gd name="connsiteX56" fmla="*/ 412750 w 1741288"/>
              <a:gd name="connsiteY56" fmla="*/ 75079 h 2411879"/>
              <a:gd name="connsiteX57" fmla="*/ 438150 w 1741288"/>
              <a:gd name="connsiteY57" fmla="*/ 56029 h 2411879"/>
              <a:gd name="connsiteX58" fmla="*/ 520700 w 1741288"/>
              <a:gd name="connsiteY58" fmla="*/ 68729 h 2411879"/>
              <a:gd name="connsiteX59" fmla="*/ 590550 w 1741288"/>
              <a:gd name="connsiteY59" fmla="*/ 94129 h 2411879"/>
              <a:gd name="connsiteX60" fmla="*/ 654050 w 1741288"/>
              <a:gd name="connsiteY60" fmla="*/ 138579 h 2411879"/>
              <a:gd name="connsiteX61" fmla="*/ 698500 w 1741288"/>
              <a:gd name="connsiteY61" fmla="*/ 176679 h 2411879"/>
              <a:gd name="connsiteX62" fmla="*/ 698500 w 1741288"/>
              <a:gd name="connsiteY62" fmla="*/ 163979 h 2411879"/>
              <a:gd name="connsiteX63" fmla="*/ 673100 w 1741288"/>
              <a:gd name="connsiteY63" fmla="*/ 113179 h 2411879"/>
              <a:gd name="connsiteX64" fmla="*/ 596900 w 1741288"/>
              <a:gd name="connsiteY64" fmla="*/ 75079 h 2411879"/>
              <a:gd name="connsiteX65" fmla="*/ 565150 w 1741288"/>
              <a:gd name="connsiteY65" fmla="*/ 36979 h 2411879"/>
              <a:gd name="connsiteX66" fmla="*/ 558800 w 1741288"/>
              <a:gd name="connsiteY66" fmla="*/ 11579 h 2411879"/>
              <a:gd name="connsiteX67" fmla="*/ 596900 w 1741288"/>
              <a:gd name="connsiteY67" fmla="*/ 5229 h 2411879"/>
              <a:gd name="connsiteX68" fmla="*/ 730250 w 1741288"/>
              <a:gd name="connsiteY68" fmla="*/ 87779 h 2411879"/>
              <a:gd name="connsiteX69" fmla="*/ 819150 w 1741288"/>
              <a:gd name="connsiteY69" fmla="*/ 176679 h 2411879"/>
              <a:gd name="connsiteX70" fmla="*/ 939800 w 1741288"/>
              <a:gd name="connsiteY70" fmla="*/ 310029 h 2411879"/>
              <a:gd name="connsiteX71" fmla="*/ 1073150 w 1741288"/>
              <a:gd name="connsiteY71" fmla="*/ 481479 h 2411879"/>
              <a:gd name="connsiteX72" fmla="*/ 1212850 w 1741288"/>
              <a:gd name="connsiteY72" fmla="*/ 621179 h 2411879"/>
              <a:gd name="connsiteX73" fmla="*/ 1327150 w 1741288"/>
              <a:gd name="connsiteY73" fmla="*/ 741829 h 2411879"/>
              <a:gd name="connsiteX74" fmla="*/ 1428750 w 1741288"/>
              <a:gd name="connsiteY74" fmla="*/ 881529 h 2411879"/>
              <a:gd name="connsiteX75" fmla="*/ 1498600 w 1741288"/>
              <a:gd name="connsiteY75" fmla="*/ 951379 h 2411879"/>
              <a:gd name="connsiteX76" fmla="*/ 1568450 w 1741288"/>
              <a:gd name="connsiteY76" fmla="*/ 1046629 h 2411879"/>
              <a:gd name="connsiteX77" fmla="*/ 1657350 w 1741288"/>
              <a:gd name="connsiteY77" fmla="*/ 1211729 h 2411879"/>
              <a:gd name="connsiteX78" fmla="*/ 1720850 w 1741288"/>
              <a:gd name="connsiteY78" fmla="*/ 1326029 h 2411879"/>
              <a:gd name="connsiteX79" fmla="*/ 1739900 w 1741288"/>
              <a:gd name="connsiteY79" fmla="*/ 1370479 h 2411879"/>
              <a:gd name="connsiteX80" fmla="*/ 1689100 w 1741288"/>
              <a:gd name="connsiteY80" fmla="*/ 1440329 h 2411879"/>
              <a:gd name="connsiteX81" fmla="*/ 1498600 w 1741288"/>
              <a:gd name="connsiteY81" fmla="*/ 1592729 h 2411879"/>
              <a:gd name="connsiteX82" fmla="*/ 1225550 w 1741288"/>
              <a:gd name="connsiteY82" fmla="*/ 1738779 h 2411879"/>
              <a:gd name="connsiteX83" fmla="*/ 952500 w 1741288"/>
              <a:gd name="connsiteY83" fmla="*/ 1840379 h 2411879"/>
              <a:gd name="connsiteX84" fmla="*/ 704850 w 1741288"/>
              <a:gd name="connsiteY84" fmla="*/ 1878479 h 2411879"/>
              <a:gd name="connsiteX85" fmla="*/ 565150 w 1741288"/>
              <a:gd name="connsiteY85" fmla="*/ 1941979 h 2411879"/>
              <a:gd name="connsiteX86" fmla="*/ 527050 w 1741288"/>
              <a:gd name="connsiteY86" fmla="*/ 2100729 h 2411879"/>
              <a:gd name="connsiteX87" fmla="*/ 527050 w 1741288"/>
              <a:gd name="connsiteY87" fmla="*/ 2221379 h 2411879"/>
              <a:gd name="connsiteX88" fmla="*/ 501650 w 1741288"/>
              <a:gd name="connsiteY88" fmla="*/ 2411879 h 2411879"/>
              <a:gd name="connsiteX0" fmla="*/ 0 w 1741288"/>
              <a:gd name="connsiteY0" fmla="*/ 1138704 h 2221379"/>
              <a:gd name="connsiteX1" fmla="*/ 31750 w 1741288"/>
              <a:gd name="connsiteY1" fmla="*/ 1275229 h 2221379"/>
              <a:gd name="connsiteX2" fmla="*/ 50800 w 1741288"/>
              <a:gd name="connsiteY2" fmla="*/ 1351429 h 2221379"/>
              <a:gd name="connsiteX3" fmla="*/ 234950 w 1741288"/>
              <a:gd name="connsiteY3" fmla="*/ 1414929 h 2221379"/>
              <a:gd name="connsiteX4" fmla="*/ 368300 w 1741288"/>
              <a:gd name="connsiteY4" fmla="*/ 1395879 h 2221379"/>
              <a:gd name="connsiteX5" fmla="*/ 501650 w 1741288"/>
              <a:gd name="connsiteY5" fmla="*/ 1364129 h 2221379"/>
              <a:gd name="connsiteX6" fmla="*/ 768350 w 1741288"/>
              <a:gd name="connsiteY6" fmla="*/ 1395879 h 2221379"/>
              <a:gd name="connsiteX7" fmla="*/ 844550 w 1741288"/>
              <a:gd name="connsiteY7" fmla="*/ 1383179 h 2221379"/>
              <a:gd name="connsiteX8" fmla="*/ 977900 w 1741288"/>
              <a:gd name="connsiteY8" fmla="*/ 1351429 h 2221379"/>
              <a:gd name="connsiteX9" fmla="*/ 1111250 w 1741288"/>
              <a:gd name="connsiteY9" fmla="*/ 1319679 h 2221379"/>
              <a:gd name="connsiteX10" fmla="*/ 1212850 w 1741288"/>
              <a:gd name="connsiteY10" fmla="*/ 1300629 h 2221379"/>
              <a:gd name="connsiteX11" fmla="*/ 1263650 w 1741288"/>
              <a:gd name="connsiteY11" fmla="*/ 1287929 h 2221379"/>
              <a:gd name="connsiteX12" fmla="*/ 1181100 w 1741288"/>
              <a:gd name="connsiteY12" fmla="*/ 1141879 h 2221379"/>
              <a:gd name="connsiteX13" fmla="*/ 1111250 w 1741288"/>
              <a:gd name="connsiteY13" fmla="*/ 983129 h 2221379"/>
              <a:gd name="connsiteX14" fmla="*/ 1022350 w 1741288"/>
              <a:gd name="connsiteY14" fmla="*/ 849779 h 2221379"/>
              <a:gd name="connsiteX15" fmla="*/ 901700 w 1741288"/>
              <a:gd name="connsiteY15" fmla="*/ 684679 h 2221379"/>
              <a:gd name="connsiteX16" fmla="*/ 812800 w 1741288"/>
              <a:gd name="connsiteY16" fmla="*/ 589429 h 2221379"/>
              <a:gd name="connsiteX17" fmla="*/ 692150 w 1741288"/>
              <a:gd name="connsiteY17" fmla="*/ 583079 h 2221379"/>
              <a:gd name="connsiteX18" fmla="*/ 641350 w 1741288"/>
              <a:gd name="connsiteY18" fmla="*/ 583079 h 2221379"/>
              <a:gd name="connsiteX19" fmla="*/ 565150 w 1741288"/>
              <a:gd name="connsiteY19" fmla="*/ 544979 h 2221379"/>
              <a:gd name="connsiteX20" fmla="*/ 514350 w 1741288"/>
              <a:gd name="connsiteY20" fmla="*/ 519579 h 2221379"/>
              <a:gd name="connsiteX21" fmla="*/ 463550 w 1741288"/>
              <a:gd name="connsiteY21" fmla="*/ 487829 h 2221379"/>
              <a:gd name="connsiteX22" fmla="*/ 419100 w 1741288"/>
              <a:gd name="connsiteY22" fmla="*/ 475129 h 2221379"/>
              <a:gd name="connsiteX23" fmla="*/ 406400 w 1741288"/>
              <a:gd name="connsiteY23" fmla="*/ 449729 h 2221379"/>
              <a:gd name="connsiteX24" fmla="*/ 438150 w 1741288"/>
              <a:gd name="connsiteY24" fmla="*/ 430679 h 2221379"/>
              <a:gd name="connsiteX25" fmla="*/ 514350 w 1741288"/>
              <a:gd name="connsiteY25" fmla="*/ 443379 h 2221379"/>
              <a:gd name="connsiteX26" fmla="*/ 558800 w 1741288"/>
              <a:gd name="connsiteY26" fmla="*/ 468779 h 2221379"/>
              <a:gd name="connsiteX27" fmla="*/ 590550 w 1741288"/>
              <a:gd name="connsiteY27" fmla="*/ 456079 h 2221379"/>
              <a:gd name="connsiteX28" fmla="*/ 590550 w 1741288"/>
              <a:gd name="connsiteY28" fmla="*/ 462429 h 2221379"/>
              <a:gd name="connsiteX29" fmla="*/ 558800 w 1741288"/>
              <a:gd name="connsiteY29" fmla="*/ 411629 h 2221379"/>
              <a:gd name="connsiteX30" fmla="*/ 488950 w 1741288"/>
              <a:gd name="connsiteY30" fmla="*/ 360829 h 2221379"/>
              <a:gd name="connsiteX31" fmla="*/ 393700 w 1741288"/>
              <a:gd name="connsiteY31" fmla="*/ 322729 h 2221379"/>
              <a:gd name="connsiteX32" fmla="*/ 336550 w 1741288"/>
              <a:gd name="connsiteY32" fmla="*/ 290979 h 2221379"/>
              <a:gd name="connsiteX33" fmla="*/ 317500 w 1741288"/>
              <a:gd name="connsiteY33" fmla="*/ 259229 h 2221379"/>
              <a:gd name="connsiteX34" fmla="*/ 317500 w 1741288"/>
              <a:gd name="connsiteY34" fmla="*/ 221129 h 2221379"/>
              <a:gd name="connsiteX35" fmla="*/ 349250 w 1741288"/>
              <a:gd name="connsiteY35" fmla="*/ 214779 h 2221379"/>
              <a:gd name="connsiteX36" fmla="*/ 387350 w 1741288"/>
              <a:gd name="connsiteY36" fmla="*/ 240179 h 2221379"/>
              <a:gd name="connsiteX37" fmla="*/ 469900 w 1741288"/>
              <a:gd name="connsiteY37" fmla="*/ 278279 h 2221379"/>
              <a:gd name="connsiteX38" fmla="*/ 527050 w 1741288"/>
              <a:gd name="connsiteY38" fmla="*/ 303679 h 2221379"/>
              <a:gd name="connsiteX39" fmla="*/ 565150 w 1741288"/>
              <a:gd name="connsiteY39" fmla="*/ 322729 h 2221379"/>
              <a:gd name="connsiteX40" fmla="*/ 514350 w 1741288"/>
              <a:gd name="connsiteY40" fmla="*/ 265579 h 2221379"/>
              <a:gd name="connsiteX41" fmla="*/ 444500 w 1741288"/>
              <a:gd name="connsiteY41" fmla="*/ 221129 h 2221379"/>
              <a:gd name="connsiteX42" fmla="*/ 368300 w 1741288"/>
              <a:gd name="connsiteY42" fmla="*/ 189379 h 2221379"/>
              <a:gd name="connsiteX43" fmla="*/ 336550 w 1741288"/>
              <a:gd name="connsiteY43" fmla="*/ 170329 h 2221379"/>
              <a:gd name="connsiteX44" fmla="*/ 304800 w 1741288"/>
              <a:gd name="connsiteY44" fmla="*/ 106829 h 2221379"/>
              <a:gd name="connsiteX45" fmla="*/ 349250 w 1741288"/>
              <a:gd name="connsiteY45" fmla="*/ 94129 h 2221379"/>
              <a:gd name="connsiteX46" fmla="*/ 406400 w 1741288"/>
              <a:gd name="connsiteY46" fmla="*/ 119529 h 2221379"/>
              <a:gd name="connsiteX47" fmla="*/ 495300 w 1741288"/>
              <a:gd name="connsiteY47" fmla="*/ 157629 h 2221379"/>
              <a:gd name="connsiteX48" fmla="*/ 571500 w 1741288"/>
              <a:gd name="connsiteY48" fmla="*/ 202079 h 2221379"/>
              <a:gd name="connsiteX49" fmla="*/ 622300 w 1741288"/>
              <a:gd name="connsiteY49" fmla="*/ 233829 h 2221379"/>
              <a:gd name="connsiteX50" fmla="*/ 635000 w 1741288"/>
              <a:gd name="connsiteY50" fmla="*/ 233829 h 2221379"/>
              <a:gd name="connsiteX51" fmla="*/ 596900 w 1741288"/>
              <a:gd name="connsiteY51" fmla="*/ 189379 h 2221379"/>
              <a:gd name="connsiteX52" fmla="*/ 546100 w 1741288"/>
              <a:gd name="connsiteY52" fmla="*/ 151279 h 2221379"/>
              <a:gd name="connsiteX53" fmla="*/ 476250 w 1741288"/>
              <a:gd name="connsiteY53" fmla="*/ 119529 h 2221379"/>
              <a:gd name="connsiteX54" fmla="*/ 431800 w 1741288"/>
              <a:gd name="connsiteY54" fmla="*/ 113179 h 2221379"/>
              <a:gd name="connsiteX55" fmla="*/ 406400 w 1741288"/>
              <a:gd name="connsiteY55" fmla="*/ 94129 h 2221379"/>
              <a:gd name="connsiteX56" fmla="*/ 412750 w 1741288"/>
              <a:gd name="connsiteY56" fmla="*/ 75079 h 2221379"/>
              <a:gd name="connsiteX57" fmla="*/ 438150 w 1741288"/>
              <a:gd name="connsiteY57" fmla="*/ 56029 h 2221379"/>
              <a:gd name="connsiteX58" fmla="*/ 520700 w 1741288"/>
              <a:gd name="connsiteY58" fmla="*/ 68729 h 2221379"/>
              <a:gd name="connsiteX59" fmla="*/ 590550 w 1741288"/>
              <a:gd name="connsiteY59" fmla="*/ 94129 h 2221379"/>
              <a:gd name="connsiteX60" fmla="*/ 654050 w 1741288"/>
              <a:gd name="connsiteY60" fmla="*/ 138579 h 2221379"/>
              <a:gd name="connsiteX61" fmla="*/ 698500 w 1741288"/>
              <a:gd name="connsiteY61" fmla="*/ 176679 h 2221379"/>
              <a:gd name="connsiteX62" fmla="*/ 698500 w 1741288"/>
              <a:gd name="connsiteY62" fmla="*/ 163979 h 2221379"/>
              <a:gd name="connsiteX63" fmla="*/ 673100 w 1741288"/>
              <a:gd name="connsiteY63" fmla="*/ 113179 h 2221379"/>
              <a:gd name="connsiteX64" fmla="*/ 596900 w 1741288"/>
              <a:gd name="connsiteY64" fmla="*/ 75079 h 2221379"/>
              <a:gd name="connsiteX65" fmla="*/ 565150 w 1741288"/>
              <a:gd name="connsiteY65" fmla="*/ 36979 h 2221379"/>
              <a:gd name="connsiteX66" fmla="*/ 558800 w 1741288"/>
              <a:gd name="connsiteY66" fmla="*/ 11579 h 2221379"/>
              <a:gd name="connsiteX67" fmla="*/ 596900 w 1741288"/>
              <a:gd name="connsiteY67" fmla="*/ 5229 h 2221379"/>
              <a:gd name="connsiteX68" fmla="*/ 730250 w 1741288"/>
              <a:gd name="connsiteY68" fmla="*/ 87779 h 2221379"/>
              <a:gd name="connsiteX69" fmla="*/ 819150 w 1741288"/>
              <a:gd name="connsiteY69" fmla="*/ 176679 h 2221379"/>
              <a:gd name="connsiteX70" fmla="*/ 939800 w 1741288"/>
              <a:gd name="connsiteY70" fmla="*/ 310029 h 2221379"/>
              <a:gd name="connsiteX71" fmla="*/ 1073150 w 1741288"/>
              <a:gd name="connsiteY71" fmla="*/ 481479 h 2221379"/>
              <a:gd name="connsiteX72" fmla="*/ 1212850 w 1741288"/>
              <a:gd name="connsiteY72" fmla="*/ 621179 h 2221379"/>
              <a:gd name="connsiteX73" fmla="*/ 1327150 w 1741288"/>
              <a:gd name="connsiteY73" fmla="*/ 741829 h 2221379"/>
              <a:gd name="connsiteX74" fmla="*/ 1428750 w 1741288"/>
              <a:gd name="connsiteY74" fmla="*/ 881529 h 2221379"/>
              <a:gd name="connsiteX75" fmla="*/ 1498600 w 1741288"/>
              <a:gd name="connsiteY75" fmla="*/ 951379 h 2221379"/>
              <a:gd name="connsiteX76" fmla="*/ 1568450 w 1741288"/>
              <a:gd name="connsiteY76" fmla="*/ 1046629 h 2221379"/>
              <a:gd name="connsiteX77" fmla="*/ 1657350 w 1741288"/>
              <a:gd name="connsiteY77" fmla="*/ 1211729 h 2221379"/>
              <a:gd name="connsiteX78" fmla="*/ 1720850 w 1741288"/>
              <a:gd name="connsiteY78" fmla="*/ 1326029 h 2221379"/>
              <a:gd name="connsiteX79" fmla="*/ 1739900 w 1741288"/>
              <a:gd name="connsiteY79" fmla="*/ 1370479 h 2221379"/>
              <a:gd name="connsiteX80" fmla="*/ 1689100 w 1741288"/>
              <a:gd name="connsiteY80" fmla="*/ 1440329 h 2221379"/>
              <a:gd name="connsiteX81" fmla="*/ 1498600 w 1741288"/>
              <a:gd name="connsiteY81" fmla="*/ 1592729 h 2221379"/>
              <a:gd name="connsiteX82" fmla="*/ 1225550 w 1741288"/>
              <a:gd name="connsiteY82" fmla="*/ 1738779 h 2221379"/>
              <a:gd name="connsiteX83" fmla="*/ 952500 w 1741288"/>
              <a:gd name="connsiteY83" fmla="*/ 1840379 h 2221379"/>
              <a:gd name="connsiteX84" fmla="*/ 704850 w 1741288"/>
              <a:gd name="connsiteY84" fmla="*/ 1878479 h 2221379"/>
              <a:gd name="connsiteX85" fmla="*/ 565150 w 1741288"/>
              <a:gd name="connsiteY85" fmla="*/ 1941979 h 2221379"/>
              <a:gd name="connsiteX86" fmla="*/ 527050 w 1741288"/>
              <a:gd name="connsiteY86" fmla="*/ 2100729 h 2221379"/>
              <a:gd name="connsiteX87" fmla="*/ 527050 w 1741288"/>
              <a:gd name="connsiteY87" fmla="*/ 2221379 h 2221379"/>
              <a:gd name="connsiteX0" fmla="*/ 0 w 1741288"/>
              <a:gd name="connsiteY0" fmla="*/ 1138704 h 2100729"/>
              <a:gd name="connsiteX1" fmla="*/ 31750 w 1741288"/>
              <a:gd name="connsiteY1" fmla="*/ 1275229 h 2100729"/>
              <a:gd name="connsiteX2" fmla="*/ 50800 w 1741288"/>
              <a:gd name="connsiteY2" fmla="*/ 1351429 h 2100729"/>
              <a:gd name="connsiteX3" fmla="*/ 234950 w 1741288"/>
              <a:gd name="connsiteY3" fmla="*/ 1414929 h 2100729"/>
              <a:gd name="connsiteX4" fmla="*/ 368300 w 1741288"/>
              <a:gd name="connsiteY4" fmla="*/ 1395879 h 2100729"/>
              <a:gd name="connsiteX5" fmla="*/ 501650 w 1741288"/>
              <a:gd name="connsiteY5" fmla="*/ 1364129 h 2100729"/>
              <a:gd name="connsiteX6" fmla="*/ 768350 w 1741288"/>
              <a:gd name="connsiteY6" fmla="*/ 1395879 h 2100729"/>
              <a:gd name="connsiteX7" fmla="*/ 844550 w 1741288"/>
              <a:gd name="connsiteY7" fmla="*/ 1383179 h 2100729"/>
              <a:gd name="connsiteX8" fmla="*/ 977900 w 1741288"/>
              <a:gd name="connsiteY8" fmla="*/ 1351429 h 2100729"/>
              <a:gd name="connsiteX9" fmla="*/ 1111250 w 1741288"/>
              <a:gd name="connsiteY9" fmla="*/ 1319679 h 2100729"/>
              <a:gd name="connsiteX10" fmla="*/ 1212850 w 1741288"/>
              <a:gd name="connsiteY10" fmla="*/ 1300629 h 2100729"/>
              <a:gd name="connsiteX11" fmla="*/ 1263650 w 1741288"/>
              <a:gd name="connsiteY11" fmla="*/ 1287929 h 2100729"/>
              <a:gd name="connsiteX12" fmla="*/ 1181100 w 1741288"/>
              <a:gd name="connsiteY12" fmla="*/ 1141879 h 2100729"/>
              <a:gd name="connsiteX13" fmla="*/ 1111250 w 1741288"/>
              <a:gd name="connsiteY13" fmla="*/ 983129 h 2100729"/>
              <a:gd name="connsiteX14" fmla="*/ 1022350 w 1741288"/>
              <a:gd name="connsiteY14" fmla="*/ 849779 h 2100729"/>
              <a:gd name="connsiteX15" fmla="*/ 901700 w 1741288"/>
              <a:gd name="connsiteY15" fmla="*/ 684679 h 2100729"/>
              <a:gd name="connsiteX16" fmla="*/ 812800 w 1741288"/>
              <a:gd name="connsiteY16" fmla="*/ 589429 h 2100729"/>
              <a:gd name="connsiteX17" fmla="*/ 692150 w 1741288"/>
              <a:gd name="connsiteY17" fmla="*/ 583079 h 2100729"/>
              <a:gd name="connsiteX18" fmla="*/ 641350 w 1741288"/>
              <a:gd name="connsiteY18" fmla="*/ 583079 h 2100729"/>
              <a:gd name="connsiteX19" fmla="*/ 565150 w 1741288"/>
              <a:gd name="connsiteY19" fmla="*/ 544979 h 2100729"/>
              <a:gd name="connsiteX20" fmla="*/ 514350 w 1741288"/>
              <a:gd name="connsiteY20" fmla="*/ 519579 h 2100729"/>
              <a:gd name="connsiteX21" fmla="*/ 463550 w 1741288"/>
              <a:gd name="connsiteY21" fmla="*/ 487829 h 2100729"/>
              <a:gd name="connsiteX22" fmla="*/ 419100 w 1741288"/>
              <a:gd name="connsiteY22" fmla="*/ 475129 h 2100729"/>
              <a:gd name="connsiteX23" fmla="*/ 406400 w 1741288"/>
              <a:gd name="connsiteY23" fmla="*/ 449729 h 2100729"/>
              <a:gd name="connsiteX24" fmla="*/ 438150 w 1741288"/>
              <a:gd name="connsiteY24" fmla="*/ 430679 h 2100729"/>
              <a:gd name="connsiteX25" fmla="*/ 514350 w 1741288"/>
              <a:gd name="connsiteY25" fmla="*/ 443379 h 2100729"/>
              <a:gd name="connsiteX26" fmla="*/ 558800 w 1741288"/>
              <a:gd name="connsiteY26" fmla="*/ 468779 h 2100729"/>
              <a:gd name="connsiteX27" fmla="*/ 590550 w 1741288"/>
              <a:gd name="connsiteY27" fmla="*/ 456079 h 2100729"/>
              <a:gd name="connsiteX28" fmla="*/ 590550 w 1741288"/>
              <a:gd name="connsiteY28" fmla="*/ 462429 h 2100729"/>
              <a:gd name="connsiteX29" fmla="*/ 558800 w 1741288"/>
              <a:gd name="connsiteY29" fmla="*/ 411629 h 2100729"/>
              <a:gd name="connsiteX30" fmla="*/ 488950 w 1741288"/>
              <a:gd name="connsiteY30" fmla="*/ 360829 h 2100729"/>
              <a:gd name="connsiteX31" fmla="*/ 393700 w 1741288"/>
              <a:gd name="connsiteY31" fmla="*/ 322729 h 2100729"/>
              <a:gd name="connsiteX32" fmla="*/ 336550 w 1741288"/>
              <a:gd name="connsiteY32" fmla="*/ 290979 h 2100729"/>
              <a:gd name="connsiteX33" fmla="*/ 317500 w 1741288"/>
              <a:gd name="connsiteY33" fmla="*/ 259229 h 2100729"/>
              <a:gd name="connsiteX34" fmla="*/ 317500 w 1741288"/>
              <a:gd name="connsiteY34" fmla="*/ 221129 h 2100729"/>
              <a:gd name="connsiteX35" fmla="*/ 349250 w 1741288"/>
              <a:gd name="connsiteY35" fmla="*/ 214779 h 2100729"/>
              <a:gd name="connsiteX36" fmla="*/ 387350 w 1741288"/>
              <a:gd name="connsiteY36" fmla="*/ 240179 h 2100729"/>
              <a:gd name="connsiteX37" fmla="*/ 469900 w 1741288"/>
              <a:gd name="connsiteY37" fmla="*/ 278279 h 2100729"/>
              <a:gd name="connsiteX38" fmla="*/ 527050 w 1741288"/>
              <a:gd name="connsiteY38" fmla="*/ 303679 h 2100729"/>
              <a:gd name="connsiteX39" fmla="*/ 565150 w 1741288"/>
              <a:gd name="connsiteY39" fmla="*/ 322729 h 2100729"/>
              <a:gd name="connsiteX40" fmla="*/ 514350 w 1741288"/>
              <a:gd name="connsiteY40" fmla="*/ 265579 h 2100729"/>
              <a:gd name="connsiteX41" fmla="*/ 444500 w 1741288"/>
              <a:gd name="connsiteY41" fmla="*/ 221129 h 2100729"/>
              <a:gd name="connsiteX42" fmla="*/ 368300 w 1741288"/>
              <a:gd name="connsiteY42" fmla="*/ 189379 h 2100729"/>
              <a:gd name="connsiteX43" fmla="*/ 336550 w 1741288"/>
              <a:gd name="connsiteY43" fmla="*/ 170329 h 2100729"/>
              <a:gd name="connsiteX44" fmla="*/ 304800 w 1741288"/>
              <a:gd name="connsiteY44" fmla="*/ 106829 h 2100729"/>
              <a:gd name="connsiteX45" fmla="*/ 349250 w 1741288"/>
              <a:gd name="connsiteY45" fmla="*/ 94129 h 2100729"/>
              <a:gd name="connsiteX46" fmla="*/ 406400 w 1741288"/>
              <a:gd name="connsiteY46" fmla="*/ 119529 h 2100729"/>
              <a:gd name="connsiteX47" fmla="*/ 495300 w 1741288"/>
              <a:gd name="connsiteY47" fmla="*/ 157629 h 2100729"/>
              <a:gd name="connsiteX48" fmla="*/ 571500 w 1741288"/>
              <a:gd name="connsiteY48" fmla="*/ 202079 h 2100729"/>
              <a:gd name="connsiteX49" fmla="*/ 622300 w 1741288"/>
              <a:gd name="connsiteY49" fmla="*/ 233829 h 2100729"/>
              <a:gd name="connsiteX50" fmla="*/ 635000 w 1741288"/>
              <a:gd name="connsiteY50" fmla="*/ 233829 h 2100729"/>
              <a:gd name="connsiteX51" fmla="*/ 596900 w 1741288"/>
              <a:gd name="connsiteY51" fmla="*/ 189379 h 2100729"/>
              <a:gd name="connsiteX52" fmla="*/ 546100 w 1741288"/>
              <a:gd name="connsiteY52" fmla="*/ 151279 h 2100729"/>
              <a:gd name="connsiteX53" fmla="*/ 476250 w 1741288"/>
              <a:gd name="connsiteY53" fmla="*/ 119529 h 2100729"/>
              <a:gd name="connsiteX54" fmla="*/ 431800 w 1741288"/>
              <a:gd name="connsiteY54" fmla="*/ 113179 h 2100729"/>
              <a:gd name="connsiteX55" fmla="*/ 406400 w 1741288"/>
              <a:gd name="connsiteY55" fmla="*/ 94129 h 2100729"/>
              <a:gd name="connsiteX56" fmla="*/ 412750 w 1741288"/>
              <a:gd name="connsiteY56" fmla="*/ 75079 h 2100729"/>
              <a:gd name="connsiteX57" fmla="*/ 438150 w 1741288"/>
              <a:gd name="connsiteY57" fmla="*/ 56029 h 2100729"/>
              <a:gd name="connsiteX58" fmla="*/ 520700 w 1741288"/>
              <a:gd name="connsiteY58" fmla="*/ 68729 h 2100729"/>
              <a:gd name="connsiteX59" fmla="*/ 590550 w 1741288"/>
              <a:gd name="connsiteY59" fmla="*/ 94129 h 2100729"/>
              <a:gd name="connsiteX60" fmla="*/ 654050 w 1741288"/>
              <a:gd name="connsiteY60" fmla="*/ 138579 h 2100729"/>
              <a:gd name="connsiteX61" fmla="*/ 698500 w 1741288"/>
              <a:gd name="connsiteY61" fmla="*/ 176679 h 2100729"/>
              <a:gd name="connsiteX62" fmla="*/ 698500 w 1741288"/>
              <a:gd name="connsiteY62" fmla="*/ 163979 h 2100729"/>
              <a:gd name="connsiteX63" fmla="*/ 673100 w 1741288"/>
              <a:gd name="connsiteY63" fmla="*/ 113179 h 2100729"/>
              <a:gd name="connsiteX64" fmla="*/ 596900 w 1741288"/>
              <a:gd name="connsiteY64" fmla="*/ 75079 h 2100729"/>
              <a:gd name="connsiteX65" fmla="*/ 565150 w 1741288"/>
              <a:gd name="connsiteY65" fmla="*/ 36979 h 2100729"/>
              <a:gd name="connsiteX66" fmla="*/ 558800 w 1741288"/>
              <a:gd name="connsiteY66" fmla="*/ 11579 h 2100729"/>
              <a:gd name="connsiteX67" fmla="*/ 596900 w 1741288"/>
              <a:gd name="connsiteY67" fmla="*/ 5229 h 2100729"/>
              <a:gd name="connsiteX68" fmla="*/ 730250 w 1741288"/>
              <a:gd name="connsiteY68" fmla="*/ 87779 h 2100729"/>
              <a:gd name="connsiteX69" fmla="*/ 819150 w 1741288"/>
              <a:gd name="connsiteY69" fmla="*/ 176679 h 2100729"/>
              <a:gd name="connsiteX70" fmla="*/ 939800 w 1741288"/>
              <a:gd name="connsiteY70" fmla="*/ 310029 h 2100729"/>
              <a:gd name="connsiteX71" fmla="*/ 1073150 w 1741288"/>
              <a:gd name="connsiteY71" fmla="*/ 481479 h 2100729"/>
              <a:gd name="connsiteX72" fmla="*/ 1212850 w 1741288"/>
              <a:gd name="connsiteY72" fmla="*/ 621179 h 2100729"/>
              <a:gd name="connsiteX73" fmla="*/ 1327150 w 1741288"/>
              <a:gd name="connsiteY73" fmla="*/ 741829 h 2100729"/>
              <a:gd name="connsiteX74" fmla="*/ 1428750 w 1741288"/>
              <a:gd name="connsiteY74" fmla="*/ 881529 h 2100729"/>
              <a:gd name="connsiteX75" fmla="*/ 1498600 w 1741288"/>
              <a:gd name="connsiteY75" fmla="*/ 951379 h 2100729"/>
              <a:gd name="connsiteX76" fmla="*/ 1568450 w 1741288"/>
              <a:gd name="connsiteY76" fmla="*/ 1046629 h 2100729"/>
              <a:gd name="connsiteX77" fmla="*/ 1657350 w 1741288"/>
              <a:gd name="connsiteY77" fmla="*/ 1211729 h 2100729"/>
              <a:gd name="connsiteX78" fmla="*/ 1720850 w 1741288"/>
              <a:gd name="connsiteY78" fmla="*/ 1326029 h 2100729"/>
              <a:gd name="connsiteX79" fmla="*/ 1739900 w 1741288"/>
              <a:gd name="connsiteY79" fmla="*/ 1370479 h 2100729"/>
              <a:gd name="connsiteX80" fmla="*/ 1689100 w 1741288"/>
              <a:gd name="connsiteY80" fmla="*/ 1440329 h 2100729"/>
              <a:gd name="connsiteX81" fmla="*/ 1498600 w 1741288"/>
              <a:gd name="connsiteY81" fmla="*/ 1592729 h 2100729"/>
              <a:gd name="connsiteX82" fmla="*/ 1225550 w 1741288"/>
              <a:gd name="connsiteY82" fmla="*/ 1738779 h 2100729"/>
              <a:gd name="connsiteX83" fmla="*/ 952500 w 1741288"/>
              <a:gd name="connsiteY83" fmla="*/ 1840379 h 2100729"/>
              <a:gd name="connsiteX84" fmla="*/ 704850 w 1741288"/>
              <a:gd name="connsiteY84" fmla="*/ 1878479 h 2100729"/>
              <a:gd name="connsiteX85" fmla="*/ 565150 w 1741288"/>
              <a:gd name="connsiteY85" fmla="*/ 1941979 h 2100729"/>
              <a:gd name="connsiteX86" fmla="*/ 527050 w 1741288"/>
              <a:gd name="connsiteY86" fmla="*/ 2100729 h 21007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</a:cxnLst>
            <a:rect l="l" t="t" r="r" b="b"/>
            <a:pathLst>
              <a:path w="1741288" h="2100729">
                <a:moveTo>
                  <a:pt x="0" y="1138704"/>
                </a:moveTo>
                <a:cubicBezTo>
                  <a:pt x="3704" y="1185270"/>
                  <a:pt x="23283" y="1239775"/>
                  <a:pt x="31750" y="1275229"/>
                </a:cubicBezTo>
                <a:cubicBezTo>
                  <a:pt x="40217" y="1310683"/>
                  <a:pt x="16933" y="1328146"/>
                  <a:pt x="50800" y="1351429"/>
                </a:cubicBezTo>
                <a:cubicBezTo>
                  <a:pt x="84667" y="1374712"/>
                  <a:pt x="182033" y="1407521"/>
                  <a:pt x="234950" y="1414929"/>
                </a:cubicBezTo>
                <a:cubicBezTo>
                  <a:pt x="287867" y="1422337"/>
                  <a:pt x="323850" y="1404346"/>
                  <a:pt x="368300" y="1395879"/>
                </a:cubicBezTo>
                <a:cubicBezTo>
                  <a:pt x="412750" y="1387412"/>
                  <a:pt x="434975" y="1364129"/>
                  <a:pt x="501650" y="1364129"/>
                </a:cubicBezTo>
                <a:cubicBezTo>
                  <a:pt x="568325" y="1364129"/>
                  <a:pt x="711200" y="1392704"/>
                  <a:pt x="768350" y="1395879"/>
                </a:cubicBezTo>
                <a:cubicBezTo>
                  <a:pt x="825500" y="1399054"/>
                  <a:pt x="809625" y="1390587"/>
                  <a:pt x="844550" y="1383179"/>
                </a:cubicBezTo>
                <a:cubicBezTo>
                  <a:pt x="879475" y="1375771"/>
                  <a:pt x="977900" y="1351429"/>
                  <a:pt x="977900" y="1351429"/>
                </a:cubicBezTo>
                <a:lnTo>
                  <a:pt x="1111250" y="1319679"/>
                </a:lnTo>
                <a:cubicBezTo>
                  <a:pt x="1150408" y="1311212"/>
                  <a:pt x="1187450" y="1305921"/>
                  <a:pt x="1212850" y="1300629"/>
                </a:cubicBezTo>
                <a:cubicBezTo>
                  <a:pt x="1238250" y="1295337"/>
                  <a:pt x="1268942" y="1314387"/>
                  <a:pt x="1263650" y="1287929"/>
                </a:cubicBezTo>
                <a:cubicBezTo>
                  <a:pt x="1258358" y="1261471"/>
                  <a:pt x="1206500" y="1192679"/>
                  <a:pt x="1181100" y="1141879"/>
                </a:cubicBezTo>
                <a:cubicBezTo>
                  <a:pt x="1155700" y="1091079"/>
                  <a:pt x="1137708" y="1031812"/>
                  <a:pt x="1111250" y="983129"/>
                </a:cubicBezTo>
                <a:cubicBezTo>
                  <a:pt x="1084792" y="934446"/>
                  <a:pt x="1057275" y="899521"/>
                  <a:pt x="1022350" y="849779"/>
                </a:cubicBezTo>
                <a:cubicBezTo>
                  <a:pt x="987425" y="800037"/>
                  <a:pt x="936625" y="728071"/>
                  <a:pt x="901700" y="684679"/>
                </a:cubicBezTo>
                <a:cubicBezTo>
                  <a:pt x="866775" y="641287"/>
                  <a:pt x="847725" y="606362"/>
                  <a:pt x="812800" y="589429"/>
                </a:cubicBezTo>
                <a:cubicBezTo>
                  <a:pt x="777875" y="572496"/>
                  <a:pt x="720725" y="584137"/>
                  <a:pt x="692150" y="583079"/>
                </a:cubicBezTo>
                <a:cubicBezTo>
                  <a:pt x="663575" y="582021"/>
                  <a:pt x="662517" y="589429"/>
                  <a:pt x="641350" y="583079"/>
                </a:cubicBezTo>
                <a:cubicBezTo>
                  <a:pt x="620183" y="576729"/>
                  <a:pt x="565150" y="544979"/>
                  <a:pt x="565150" y="544979"/>
                </a:cubicBezTo>
                <a:cubicBezTo>
                  <a:pt x="543983" y="534396"/>
                  <a:pt x="531283" y="529104"/>
                  <a:pt x="514350" y="519579"/>
                </a:cubicBezTo>
                <a:cubicBezTo>
                  <a:pt x="497417" y="510054"/>
                  <a:pt x="479425" y="495237"/>
                  <a:pt x="463550" y="487829"/>
                </a:cubicBezTo>
                <a:cubicBezTo>
                  <a:pt x="447675" y="480421"/>
                  <a:pt x="428625" y="481479"/>
                  <a:pt x="419100" y="475129"/>
                </a:cubicBezTo>
                <a:cubicBezTo>
                  <a:pt x="409575" y="468779"/>
                  <a:pt x="403225" y="457137"/>
                  <a:pt x="406400" y="449729"/>
                </a:cubicBezTo>
                <a:cubicBezTo>
                  <a:pt x="409575" y="442321"/>
                  <a:pt x="420159" y="431737"/>
                  <a:pt x="438150" y="430679"/>
                </a:cubicBezTo>
                <a:cubicBezTo>
                  <a:pt x="456141" y="429621"/>
                  <a:pt x="494242" y="437029"/>
                  <a:pt x="514350" y="443379"/>
                </a:cubicBezTo>
                <a:cubicBezTo>
                  <a:pt x="534458" y="449729"/>
                  <a:pt x="546100" y="466662"/>
                  <a:pt x="558800" y="468779"/>
                </a:cubicBezTo>
                <a:cubicBezTo>
                  <a:pt x="571500" y="470896"/>
                  <a:pt x="585259" y="457137"/>
                  <a:pt x="590550" y="456079"/>
                </a:cubicBezTo>
                <a:cubicBezTo>
                  <a:pt x="595841" y="455021"/>
                  <a:pt x="595842" y="469837"/>
                  <a:pt x="590550" y="462429"/>
                </a:cubicBezTo>
                <a:cubicBezTo>
                  <a:pt x="585258" y="455021"/>
                  <a:pt x="575733" y="428562"/>
                  <a:pt x="558800" y="411629"/>
                </a:cubicBezTo>
                <a:cubicBezTo>
                  <a:pt x="541867" y="394696"/>
                  <a:pt x="516467" y="375646"/>
                  <a:pt x="488950" y="360829"/>
                </a:cubicBezTo>
                <a:cubicBezTo>
                  <a:pt x="461433" y="346012"/>
                  <a:pt x="419100" y="334371"/>
                  <a:pt x="393700" y="322729"/>
                </a:cubicBezTo>
                <a:cubicBezTo>
                  <a:pt x="368300" y="311087"/>
                  <a:pt x="349250" y="301562"/>
                  <a:pt x="336550" y="290979"/>
                </a:cubicBezTo>
                <a:cubicBezTo>
                  <a:pt x="323850" y="280396"/>
                  <a:pt x="320675" y="270871"/>
                  <a:pt x="317500" y="259229"/>
                </a:cubicBezTo>
                <a:cubicBezTo>
                  <a:pt x="314325" y="247587"/>
                  <a:pt x="312208" y="228537"/>
                  <a:pt x="317500" y="221129"/>
                </a:cubicBezTo>
                <a:cubicBezTo>
                  <a:pt x="322792" y="213721"/>
                  <a:pt x="337608" y="211604"/>
                  <a:pt x="349250" y="214779"/>
                </a:cubicBezTo>
                <a:cubicBezTo>
                  <a:pt x="360892" y="217954"/>
                  <a:pt x="367242" y="229596"/>
                  <a:pt x="387350" y="240179"/>
                </a:cubicBezTo>
                <a:cubicBezTo>
                  <a:pt x="407458" y="250762"/>
                  <a:pt x="446617" y="267696"/>
                  <a:pt x="469900" y="278279"/>
                </a:cubicBezTo>
                <a:cubicBezTo>
                  <a:pt x="493183" y="288862"/>
                  <a:pt x="511175" y="296271"/>
                  <a:pt x="527050" y="303679"/>
                </a:cubicBezTo>
                <a:cubicBezTo>
                  <a:pt x="542925" y="311087"/>
                  <a:pt x="567267" y="329079"/>
                  <a:pt x="565150" y="322729"/>
                </a:cubicBezTo>
                <a:cubicBezTo>
                  <a:pt x="563033" y="316379"/>
                  <a:pt x="534458" y="282512"/>
                  <a:pt x="514350" y="265579"/>
                </a:cubicBezTo>
                <a:cubicBezTo>
                  <a:pt x="494242" y="248646"/>
                  <a:pt x="468842" y="233829"/>
                  <a:pt x="444500" y="221129"/>
                </a:cubicBezTo>
                <a:cubicBezTo>
                  <a:pt x="420158" y="208429"/>
                  <a:pt x="386292" y="197846"/>
                  <a:pt x="368300" y="189379"/>
                </a:cubicBezTo>
                <a:cubicBezTo>
                  <a:pt x="350308" y="180912"/>
                  <a:pt x="347133" y="184087"/>
                  <a:pt x="336550" y="170329"/>
                </a:cubicBezTo>
                <a:cubicBezTo>
                  <a:pt x="325967" y="156571"/>
                  <a:pt x="302683" y="119529"/>
                  <a:pt x="304800" y="106829"/>
                </a:cubicBezTo>
                <a:cubicBezTo>
                  <a:pt x="306917" y="94129"/>
                  <a:pt x="332317" y="92012"/>
                  <a:pt x="349250" y="94129"/>
                </a:cubicBezTo>
                <a:cubicBezTo>
                  <a:pt x="366183" y="96246"/>
                  <a:pt x="406400" y="119529"/>
                  <a:pt x="406400" y="119529"/>
                </a:cubicBezTo>
                <a:cubicBezTo>
                  <a:pt x="430742" y="130112"/>
                  <a:pt x="467783" y="143871"/>
                  <a:pt x="495300" y="157629"/>
                </a:cubicBezTo>
                <a:cubicBezTo>
                  <a:pt x="522817" y="171387"/>
                  <a:pt x="550333" y="189379"/>
                  <a:pt x="571500" y="202079"/>
                </a:cubicBezTo>
                <a:cubicBezTo>
                  <a:pt x="592667" y="214779"/>
                  <a:pt x="611717" y="228537"/>
                  <a:pt x="622300" y="233829"/>
                </a:cubicBezTo>
                <a:cubicBezTo>
                  <a:pt x="632883" y="239121"/>
                  <a:pt x="639233" y="241237"/>
                  <a:pt x="635000" y="233829"/>
                </a:cubicBezTo>
                <a:cubicBezTo>
                  <a:pt x="630767" y="226421"/>
                  <a:pt x="611717" y="203137"/>
                  <a:pt x="596900" y="189379"/>
                </a:cubicBezTo>
                <a:cubicBezTo>
                  <a:pt x="582083" y="175621"/>
                  <a:pt x="566208" y="162921"/>
                  <a:pt x="546100" y="151279"/>
                </a:cubicBezTo>
                <a:cubicBezTo>
                  <a:pt x="525992" y="139637"/>
                  <a:pt x="495300" y="125879"/>
                  <a:pt x="476250" y="119529"/>
                </a:cubicBezTo>
                <a:cubicBezTo>
                  <a:pt x="457200" y="113179"/>
                  <a:pt x="443442" y="117412"/>
                  <a:pt x="431800" y="113179"/>
                </a:cubicBezTo>
                <a:cubicBezTo>
                  <a:pt x="420158" y="108946"/>
                  <a:pt x="409575" y="100479"/>
                  <a:pt x="406400" y="94129"/>
                </a:cubicBezTo>
                <a:cubicBezTo>
                  <a:pt x="403225" y="87779"/>
                  <a:pt x="407458" y="81429"/>
                  <a:pt x="412750" y="75079"/>
                </a:cubicBezTo>
                <a:cubicBezTo>
                  <a:pt x="418042" y="68729"/>
                  <a:pt x="420159" y="57087"/>
                  <a:pt x="438150" y="56029"/>
                </a:cubicBezTo>
                <a:cubicBezTo>
                  <a:pt x="456141" y="54971"/>
                  <a:pt x="495300" y="62379"/>
                  <a:pt x="520700" y="68729"/>
                </a:cubicBezTo>
                <a:cubicBezTo>
                  <a:pt x="546100" y="75079"/>
                  <a:pt x="568325" y="82487"/>
                  <a:pt x="590550" y="94129"/>
                </a:cubicBezTo>
                <a:cubicBezTo>
                  <a:pt x="612775" y="105771"/>
                  <a:pt x="636058" y="124821"/>
                  <a:pt x="654050" y="138579"/>
                </a:cubicBezTo>
                <a:cubicBezTo>
                  <a:pt x="672042" y="152337"/>
                  <a:pt x="691092" y="172446"/>
                  <a:pt x="698500" y="176679"/>
                </a:cubicBezTo>
                <a:cubicBezTo>
                  <a:pt x="705908" y="180912"/>
                  <a:pt x="702733" y="174562"/>
                  <a:pt x="698500" y="163979"/>
                </a:cubicBezTo>
                <a:cubicBezTo>
                  <a:pt x="694267" y="153396"/>
                  <a:pt x="690033" y="127996"/>
                  <a:pt x="673100" y="113179"/>
                </a:cubicBezTo>
                <a:cubicBezTo>
                  <a:pt x="656167" y="98362"/>
                  <a:pt x="614892" y="87779"/>
                  <a:pt x="596900" y="75079"/>
                </a:cubicBezTo>
                <a:cubicBezTo>
                  <a:pt x="578908" y="62379"/>
                  <a:pt x="571500" y="47562"/>
                  <a:pt x="565150" y="36979"/>
                </a:cubicBezTo>
                <a:cubicBezTo>
                  <a:pt x="558800" y="26396"/>
                  <a:pt x="553508" y="16871"/>
                  <a:pt x="558800" y="11579"/>
                </a:cubicBezTo>
                <a:cubicBezTo>
                  <a:pt x="564092" y="6287"/>
                  <a:pt x="568325" y="-7471"/>
                  <a:pt x="596900" y="5229"/>
                </a:cubicBezTo>
                <a:cubicBezTo>
                  <a:pt x="625475" y="17929"/>
                  <a:pt x="693208" y="59204"/>
                  <a:pt x="730250" y="87779"/>
                </a:cubicBezTo>
                <a:cubicBezTo>
                  <a:pt x="767292" y="116354"/>
                  <a:pt x="784225" y="139637"/>
                  <a:pt x="819150" y="176679"/>
                </a:cubicBezTo>
                <a:cubicBezTo>
                  <a:pt x="854075" y="213721"/>
                  <a:pt x="897467" y="259229"/>
                  <a:pt x="939800" y="310029"/>
                </a:cubicBezTo>
                <a:cubicBezTo>
                  <a:pt x="982133" y="360829"/>
                  <a:pt x="1027642" y="429621"/>
                  <a:pt x="1073150" y="481479"/>
                </a:cubicBezTo>
                <a:cubicBezTo>
                  <a:pt x="1118658" y="533337"/>
                  <a:pt x="1170517" y="577787"/>
                  <a:pt x="1212850" y="621179"/>
                </a:cubicBezTo>
                <a:cubicBezTo>
                  <a:pt x="1255183" y="664571"/>
                  <a:pt x="1291167" y="698437"/>
                  <a:pt x="1327150" y="741829"/>
                </a:cubicBezTo>
                <a:cubicBezTo>
                  <a:pt x="1363133" y="785221"/>
                  <a:pt x="1400175" y="846604"/>
                  <a:pt x="1428750" y="881529"/>
                </a:cubicBezTo>
                <a:cubicBezTo>
                  <a:pt x="1457325" y="916454"/>
                  <a:pt x="1475317" y="923862"/>
                  <a:pt x="1498600" y="951379"/>
                </a:cubicBezTo>
                <a:cubicBezTo>
                  <a:pt x="1521883" y="978896"/>
                  <a:pt x="1541992" y="1003237"/>
                  <a:pt x="1568450" y="1046629"/>
                </a:cubicBezTo>
                <a:cubicBezTo>
                  <a:pt x="1594908" y="1090021"/>
                  <a:pt x="1631950" y="1165162"/>
                  <a:pt x="1657350" y="1211729"/>
                </a:cubicBezTo>
                <a:cubicBezTo>
                  <a:pt x="1682750" y="1258296"/>
                  <a:pt x="1707092" y="1299571"/>
                  <a:pt x="1720850" y="1326029"/>
                </a:cubicBezTo>
                <a:cubicBezTo>
                  <a:pt x="1734608" y="1352487"/>
                  <a:pt x="1745192" y="1351429"/>
                  <a:pt x="1739900" y="1370479"/>
                </a:cubicBezTo>
                <a:cubicBezTo>
                  <a:pt x="1734608" y="1389529"/>
                  <a:pt x="1729317" y="1403287"/>
                  <a:pt x="1689100" y="1440329"/>
                </a:cubicBezTo>
                <a:cubicBezTo>
                  <a:pt x="1648883" y="1477371"/>
                  <a:pt x="1575858" y="1542987"/>
                  <a:pt x="1498600" y="1592729"/>
                </a:cubicBezTo>
                <a:cubicBezTo>
                  <a:pt x="1421342" y="1642471"/>
                  <a:pt x="1316567" y="1697504"/>
                  <a:pt x="1225550" y="1738779"/>
                </a:cubicBezTo>
                <a:cubicBezTo>
                  <a:pt x="1134533" y="1780054"/>
                  <a:pt x="1039283" y="1817096"/>
                  <a:pt x="952500" y="1840379"/>
                </a:cubicBezTo>
                <a:cubicBezTo>
                  <a:pt x="865717" y="1863662"/>
                  <a:pt x="769408" y="1861546"/>
                  <a:pt x="704850" y="1878479"/>
                </a:cubicBezTo>
                <a:cubicBezTo>
                  <a:pt x="640292" y="1895412"/>
                  <a:pt x="594783" y="1904937"/>
                  <a:pt x="565150" y="1941979"/>
                </a:cubicBezTo>
                <a:cubicBezTo>
                  <a:pt x="535517" y="1979021"/>
                  <a:pt x="533400" y="2054162"/>
                  <a:pt x="527050" y="2100729"/>
                </a:cubicBezTo>
              </a:path>
            </a:pathLst>
          </a:cu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2C735F9-2334-45F6-8172-C296BE78F6DB}"/>
              </a:ext>
            </a:extLst>
          </p:cNvPr>
          <p:cNvSpPr txBox="1"/>
          <p:nvPr/>
        </p:nvSpPr>
        <p:spPr>
          <a:xfrm>
            <a:off x="902339" y="1593130"/>
            <a:ext cx="2055043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Supplemental Data</a:t>
            </a:r>
          </a:p>
          <a:p>
            <a:pPr algn="ctr"/>
            <a:r>
              <a:rPr lang="en-US" dirty="0"/>
              <a:t>Movie—backwards lymphatic pulsing—click below image to find toolbar and click arrow to run embedded movie</a:t>
            </a:r>
          </a:p>
        </p:txBody>
      </p:sp>
    </p:spTree>
    <p:extLst>
      <p:ext uri="{BB962C8B-B14F-4D97-AF65-F5344CB8AC3E}">
        <p14:creationId xmlns:p14="http://schemas.microsoft.com/office/powerpoint/2010/main" val="26778000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238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1</Words>
  <Application>Microsoft Office PowerPoint</Application>
  <PresentationFormat>Widescreen</PresentationFormat>
  <Paragraphs>2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drich, Melissa B</dc:creator>
  <cp:lastModifiedBy>Aldrich, Melissa B</cp:lastModifiedBy>
  <cp:revision>3</cp:revision>
  <dcterms:created xsi:type="dcterms:W3CDTF">2025-02-06T22:54:01Z</dcterms:created>
  <dcterms:modified xsi:type="dcterms:W3CDTF">2025-02-06T22:57:33Z</dcterms:modified>
</cp:coreProperties>
</file>